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5718175" cy="5718175"/>
  <p:notesSz cx="6858000" cy="9144000"/>
  <p:defaultTextStyle>
    <a:defPPr>
      <a:defRPr lang="ja-JP"/>
    </a:defPPr>
    <a:lvl1pPr marL="0" algn="l" defTabSz="653430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1pPr>
    <a:lvl2pPr marL="326715" algn="l" defTabSz="653430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2pPr>
    <a:lvl3pPr marL="653430" algn="l" defTabSz="653430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3pPr>
    <a:lvl4pPr marL="980145" algn="l" defTabSz="653430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4pPr>
    <a:lvl5pPr marL="1306860" algn="l" defTabSz="653430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5pPr>
    <a:lvl6pPr marL="1633576" algn="l" defTabSz="653430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6pPr>
    <a:lvl7pPr marL="1960291" algn="l" defTabSz="653430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7pPr>
    <a:lvl8pPr marL="2287006" algn="l" defTabSz="653430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8pPr>
    <a:lvl9pPr marL="2613721" algn="l" defTabSz="653430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01">
          <p15:clr>
            <a:srgbClr val="A4A3A4"/>
          </p15:clr>
        </p15:guide>
        <p15:guide id="2" pos="180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4080" y="786"/>
      </p:cViewPr>
      <p:guideLst>
        <p:guide orient="horz" pos="1801"/>
        <p:guide pos="180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ocuments\2015.8.2&#20197;&#21069;&#12398;&#12501;&#12449;&#12452;&#12523;\2014.7.8%20dynabook%20data(3&#21092;&#20341;&#29992;&#12398;&#12487;&#12540;&#12479;&#12354;&#12426;)\Documents\&#23455;&#39443;&#12501;&#12449;&#12452;&#12523;&#65288;2014.3.16&#20197;&#38477;&#12289;VAIO&#12364;&#35519;&#23376;&#24746;&#12356;&#12383;&#12417;&#65289;\3&#21092;&#20341;&#29992;&#38306;&#36899;&#12487;&#12540;&#12479;\&#12476;&#12494;&#12464;&#12521;&#12501;&#12488;&#28204;&#23450;&#12487;&#12540;&#12479;\(2014.2.17&#20316;&#35069;&#12476;&#12494;&#12464;&#12521;&#12501;&#12488;)RPC-9%20&#21336;&#21092;&#8658;&#20341;&#29992;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ocuments\2015.8.2&#20197;&#21069;&#12398;&#12501;&#12449;&#12452;&#12523;\2014.7.8%20dynabook%20data(3&#21092;&#20341;&#29992;&#12398;&#12487;&#12540;&#12479;&#12354;&#12426;)\Documents\&#23455;&#39443;&#12501;&#12449;&#12452;&#12523;&#65288;2014.3.16&#20197;&#38477;&#12289;VAIO&#12364;&#35519;&#23376;&#24746;&#12356;&#12383;&#12417;&#65289;\3&#21092;&#20341;&#29992;&#38306;&#36899;&#12487;&#12540;&#12479;\&#12476;&#12494;&#12464;&#12521;&#12501;&#12488;&#28204;&#23450;&#12487;&#12540;&#12479;\(2014.2.17&#20316;&#35069;&#12476;&#12494;&#12464;&#12521;&#12501;&#12488;)RPC-9%20&#21336;&#21092;&#8658;&#20341;&#29992;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esktop\(2015.2.10&#20316;&#35069;&#12476;&#12494;&#12464;&#12521;&#12501;&#12488;)RPC-9%20&#9312;vehicle%20&#9313;afa.bev(2)%20&#9314;cet(0.1).bev(2)%20&#9315;afa.cet(0.1).bev(2)%20&#9316;AZD(25mg.kg)%202015.8.23&#20445;&#23384;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esktop\(2015.2.10&#20316;&#35069;&#12476;&#12494;&#12464;&#12521;&#12501;&#12488;)RPC-9%20&#9312;vehicle%20&#9313;afa.bev(2)%20&#9314;cet(0.1).bev(2)%20&#9315;afa.cet(0.1).bev(2)%20&#9316;AZD(25mg.kg)%202015.8.23&#20445;&#23384;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ocuments\2015.8.2&#20197;&#21069;&#12398;&#12501;&#12449;&#12452;&#12523;\2014.7.8%20dynabook%20data(3&#21092;&#20341;&#29992;&#12398;&#12487;&#12540;&#12479;&#12354;&#12426;)\Documents\&#23455;&#39443;&#12501;&#12449;&#12452;&#12523;&#65288;2014.3.16&#20197;&#38477;&#12289;VAIO&#12364;&#35519;&#23376;&#24746;&#12356;&#12383;&#12417;&#65289;\3&#21092;&#20341;&#29992;&#38306;&#36899;&#12487;&#12540;&#12479;\&#12476;&#12494;&#12464;&#12521;&#12501;&#12488;&#28204;&#23450;&#12487;&#12540;&#12479;\(2014.3.31&#20316;&#35069;&#12476;&#12494;&#12464;&#12521;&#12501;&#12488;)RPC-9%203&#21092;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ocuments\2015.8.2&#20197;&#21069;&#12398;&#12501;&#12449;&#12452;&#12523;\2014.7.8%20dynabook%20data(3&#21092;&#20341;&#29992;&#12398;&#12487;&#12540;&#12479;&#12354;&#12426;)\Documents\&#23455;&#39443;&#12501;&#12449;&#12452;&#12523;&#65288;2014.3.16&#20197;&#38477;&#12289;VAIO&#12364;&#35519;&#23376;&#24746;&#12356;&#12383;&#12417;&#65289;\3&#21092;&#20341;&#29992;&#38306;&#36899;&#12487;&#12540;&#12479;\&#12476;&#12494;&#12464;&#12521;&#12501;&#12488;&#28204;&#23450;&#12487;&#12540;&#12479;\(2014.3.31&#20316;&#35069;&#12476;&#12494;&#12464;&#12521;&#12501;&#12488;)RPC-9%203&#21092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150516997905471"/>
          <c:y val="9.8133910288606421E-2"/>
          <c:w val="0.83315760459216714"/>
          <c:h val="0.74453994022050274"/>
        </c:manualLayout>
      </c:layout>
      <c:scatterChart>
        <c:scatterStyle val="lineMarker"/>
        <c:varyColors val="0"/>
        <c:ser>
          <c:idx val="0"/>
          <c:order val="0"/>
          <c:tx>
            <c:strRef>
              <c:f>'RPC-9'!$D$246</c:f>
              <c:strCache>
                <c:ptCount val="1"/>
                <c:pt idx="0">
                  <c:v>Vehicle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165:$U$165</c:f>
                <c:numCache>
                  <c:formatCode>General</c:formatCode>
                  <c:ptCount val="17"/>
                  <c:pt idx="0">
                    <c:v>37.533083357982669</c:v>
                  </c:pt>
                  <c:pt idx="1">
                    <c:v>50.769139955103256</c:v>
                  </c:pt>
                  <c:pt idx="2">
                    <c:v>60.469579266416225</c:v>
                  </c:pt>
                  <c:pt idx="3">
                    <c:v>75.480447499411085</c:v>
                  </c:pt>
                  <c:pt idx="4">
                    <c:v>76.437843555422333</c:v>
                  </c:pt>
                  <c:pt idx="5">
                    <c:v>74.621447897001758</c:v>
                  </c:pt>
                  <c:pt idx="6">
                    <c:v>88.022816097085382</c:v>
                  </c:pt>
                  <c:pt idx="7">
                    <c:v>111.29177043500448</c:v>
                  </c:pt>
                  <c:pt idx="8">
                    <c:v>123.56118406143453</c:v>
                  </c:pt>
                  <c:pt idx="9">
                    <c:v>104.32487043719244</c:v>
                  </c:pt>
                  <c:pt idx="10">
                    <c:v>132.61968695372047</c:v>
                  </c:pt>
                  <c:pt idx="11">
                    <c:v>109.30171840908372</c:v>
                  </c:pt>
                  <c:pt idx="12">
                    <c:v>162.24324794357824</c:v>
                  </c:pt>
                  <c:pt idx="13">
                    <c:v>194.82978185728317</c:v>
                  </c:pt>
                  <c:pt idx="14">
                    <c:v>218.07393570553924</c:v>
                  </c:pt>
                  <c:pt idx="15">
                    <c:v>220.46584470438893</c:v>
                  </c:pt>
                  <c:pt idx="16">
                    <c:v>206.998747089120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45:$M$245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</c:numCache>
            </c:numRef>
          </c:xVal>
          <c:yVal>
            <c:numRef>
              <c:f>'RPC-9'!$E$246:$M$246</c:f>
              <c:numCache>
                <c:formatCode>General</c:formatCode>
                <c:ptCount val="9"/>
                <c:pt idx="0">
                  <c:v>191.01654485714289</c:v>
                </c:pt>
                <c:pt idx="1">
                  <c:v>312.19474214285714</c:v>
                </c:pt>
                <c:pt idx="2">
                  <c:v>392.25965985714282</c:v>
                </c:pt>
                <c:pt idx="3">
                  <c:v>506.76435878571431</c:v>
                </c:pt>
                <c:pt idx="4">
                  <c:v>635.8670707857143</c:v>
                </c:pt>
                <c:pt idx="5">
                  <c:v>715.59988757142855</c:v>
                </c:pt>
                <c:pt idx="6">
                  <c:v>812.46987371428565</c:v>
                </c:pt>
                <c:pt idx="7">
                  <c:v>913.14254092857129</c:v>
                </c:pt>
                <c:pt idx="8">
                  <c:v>979.6279307142857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RPC-9'!$D$247</c:f>
              <c:strCache>
                <c:ptCount val="1"/>
                <c:pt idx="0">
                  <c:v>Afa(10)</c:v>
                </c:pt>
              </c:strCache>
            </c:strRef>
          </c:tx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176:$U$176</c:f>
                <c:numCache>
                  <c:formatCode>General</c:formatCode>
                  <c:ptCount val="17"/>
                  <c:pt idx="0">
                    <c:v>10.24958915139003</c:v>
                  </c:pt>
                  <c:pt idx="1">
                    <c:v>15.39719472684466</c:v>
                  </c:pt>
                  <c:pt idx="2">
                    <c:v>22.218139999097328</c:v>
                  </c:pt>
                  <c:pt idx="3">
                    <c:v>48.340732691131159</c:v>
                  </c:pt>
                  <c:pt idx="4">
                    <c:v>47.169885765987921</c:v>
                  </c:pt>
                  <c:pt idx="5">
                    <c:v>79.123281859673298</c:v>
                  </c:pt>
                  <c:pt idx="6">
                    <c:v>74.08642658901374</c:v>
                  </c:pt>
                  <c:pt idx="7">
                    <c:v>86.579806108628404</c:v>
                  </c:pt>
                  <c:pt idx="8">
                    <c:v>99.760742613541993</c:v>
                  </c:pt>
                  <c:pt idx="9">
                    <c:v>130.989347411278</c:v>
                  </c:pt>
                  <c:pt idx="10">
                    <c:v>89.697110815156819</c:v>
                  </c:pt>
                  <c:pt idx="11">
                    <c:v>97.57423278498095</c:v>
                  </c:pt>
                  <c:pt idx="12">
                    <c:v>89.942580904021398</c:v>
                  </c:pt>
                  <c:pt idx="13">
                    <c:v>72.907758408016534</c:v>
                  </c:pt>
                  <c:pt idx="14">
                    <c:v>33.637847852858947</c:v>
                  </c:pt>
                  <c:pt idx="15">
                    <c:v>48.208531429805113</c:v>
                  </c:pt>
                  <c:pt idx="16">
                    <c:v>69.4388662721897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45:$M$245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</c:numCache>
            </c:numRef>
          </c:xVal>
          <c:yVal>
            <c:numRef>
              <c:f>'RPC-9'!$E$247:$M$247</c:f>
              <c:numCache>
                <c:formatCode>General</c:formatCode>
                <c:ptCount val="9"/>
                <c:pt idx="0">
                  <c:v>137.84660233333332</c:v>
                </c:pt>
                <c:pt idx="1">
                  <c:v>173.70133766666663</c:v>
                </c:pt>
                <c:pt idx="2">
                  <c:v>189.77531025000005</c:v>
                </c:pt>
                <c:pt idx="3">
                  <c:v>259.32787399999995</c:v>
                </c:pt>
                <c:pt idx="4">
                  <c:v>267.94909033333334</c:v>
                </c:pt>
                <c:pt idx="5">
                  <c:v>367.40480025000005</c:v>
                </c:pt>
                <c:pt idx="6">
                  <c:v>384.7743011666667</c:v>
                </c:pt>
                <c:pt idx="7">
                  <c:v>537.60732908333341</c:v>
                </c:pt>
                <c:pt idx="8">
                  <c:v>596.18455675000007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RPC-9'!$D$248</c:f>
              <c:strCache>
                <c:ptCount val="1"/>
                <c:pt idx="0">
                  <c:v>Cet(0.1)</c:v>
                </c:pt>
              </c:strCache>
            </c:strRef>
          </c:tx>
          <c:spPr>
            <a:ln w="12700">
              <a:solidFill>
                <a:srgbClr val="7030A0"/>
              </a:solidFill>
              <a:prstDash val="sysDot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186:$U$186</c:f>
                <c:numCache>
                  <c:formatCode>General</c:formatCode>
                  <c:ptCount val="17"/>
                  <c:pt idx="0">
                    <c:v>52.420080275869694</c:v>
                  </c:pt>
                  <c:pt idx="1">
                    <c:v>68.013857802267836</c:v>
                  </c:pt>
                  <c:pt idx="2">
                    <c:v>70.709549789740862</c:v>
                  </c:pt>
                  <c:pt idx="3">
                    <c:v>100.21307132314206</c:v>
                  </c:pt>
                  <c:pt idx="4">
                    <c:v>105.54613730885862</c:v>
                  </c:pt>
                  <c:pt idx="5">
                    <c:v>130.23412137154625</c:v>
                  </c:pt>
                  <c:pt idx="6">
                    <c:v>135.77423520431617</c:v>
                  </c:pt>
                  <c:pt idx="7">
                    <c:v>160.57284374236775</c:v>
                  </c:pt>
                  <c:pt idx="8">
                    <c:v>158.16383408156838</c:v>
                  </c:pt>
                  <c:pt idx="9">
                    <c:v>152.90113230884324</c:v>
                  </c:pt>
                  <c:pt idx="10">
                    <c:v>137.38272974052887</c:v>
                  </c:pt>
                  <c:pt idx="11">
                    <c:v>109.39063222507798</c:v>
                  </c:pt>
                  <c:pt idx="12">
                    <c:v>95.744815859961065</c:v>
                  </c:pt>
                  <c:pt idx="13">
                    <c:v>41.042643805598473</c:v>
                  </c:pt>
                  <c:pt idx="14">
                    <c:v>51.740824444911539</c:v>
                  </c:pt>
                  <c:pt idx="15">
                    <c:v>41.927078759210772</c:v>
                  </c:pt>
                  <c:pt idx="16">
                    <c:v>32.90361478689312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45:$M$245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</c:numCache>
            </c:numRef>
          </c:xVal>
          <c:yVal>
            <c:numRef>
              <c:f>'RPC-9'!$E$248:$M$248</c:f>
              <c:numCache>
                <c:formatCode>General</c:formatCode>
                <c:ptCount val="9"/>
                <c:pt idx="0">
                  <c:v>180.57706341666665</c:v>
                </c:pt>
                <c:pt idx="1">
                  <c:v>196.2612895</c:v>
                </c:pt>
                <c:pt idx="2">
                  <c:v>233.41587716666666</c:v>
                </c:pt>
                <c:pt idx="3">
                  <c:v>306.07412366666671</c:v>
                </c:pt>
                <c:pt idx="4">
                  <c:v>338.5939105833333</c:v>
                </c:pt>
                <c:pt idx="5">
                  <c:v>382.91263325</c:v>
                </c:pt>
                <c:pt idx="6">
                  <c:v>400.41157908333338</c:v>
                </c:pt>
                <c:pt idx="7">
                  <c:v>470.99144899999993</c:v>
                </c:pt>
                <c:pt idx="8">
                  <c:v>526.87124125000003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RPC-9'!$D$249</c:f>
              <c:strCache>
                <c:ptCount val="1"/>
                <c:pt idx="0">
                  <c:v>Bev(2)</c:v>
                </c:pt>
              </c:strCache>
            </c:strRef>
          </c:tx>
          <c:spPr>
            <a:ln w="12700">
              <a:solidFill>
                <a:srgbClr val="C00000"/>
              </a:solidFill>
              <a:prstDash val="sysDash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196:$U$196</c:f>
                <c:numCache>
                  <c:formatCode>General</c:formatCode>
                  <c:ptCount val="17"/>
                  <c:pt idx="0">
                    <c:v>41.71687418075367</c:v>
                  </c:pt>
                  <c:pt idx="1">
                    <c:v>45.971114048350628</c:v>
                  </c:pt>
                  <c:pt idx="2">
                    <c:v>41.582326614393892</c:v>
                  </c:pt>
                  <c:pt idx="3">
                    <c:v>56.987348371597903</c:v>
                  </c:pt>
                  <c:pt idx="4">
                    <c:v>59.464298542045178</c:v>
                  </c:pt>
                  <c:pt idx="5">
                    <c:v>52.711831924230154</c:v>
                  </c:pt>
                  <c:pt idx="6">
                    <c:v>57.94117048532317</c:v>
                  </c:pt>
                  <c:pt idx="7">
                    <c:v>73.885777798339589</c:v>
                  </c:pt>
                  <c:pt idx="8">
                    <c:v>75.241560110903535</c:v>
                  </c:pt>
                  <c:pt idx="9">
                    <c:v>47.826647303218436</c:v>
                  </c:pt>
                  <c:pt idx="10">
                    <c:v>45.446712489750972</c:v>
                  </c:pt>
                  <c:pt idx="11">
                    <c:v>57.7357924273145</c:v>
                  </c:pt>
                  <c:pt idx="12">
                    <c:v>48.811508129925123</c:v>
                  </c:pt>
                  <c:pt idx="13">
                    <c:v>55.014035902329788</c:v>
                  </c:pt>
                  <c:pt idx="14">
                    <c:v>47.077513101064341</c:v>
                  </c:pt>
                  <c:pt idx="15">
                    <c:v>39.311421039890995</c:v>
                  </c:pt>
                  <c:pt idx="16">
                    <c:v>45.5875979101816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45:$M$245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</c:numCache>
            </c:numRef>
          </c:xVal>
          <c:yVal>
            <c:numRef>
              <c:f>'RPC-9'!$E$249:$M$249</c:f>
              <c:numCache>
                <c:formatCode>General</c:formatCode>
                <c:ptCount val="9"/>
                <c:pt idx="0">
                  <c:v>234.88858941666669</c:v>
                </c:pt>
                <c:pt idx="1">
                  <c:v>241.17241249999998</c:v>
                </c:pt>
                <c:pt idx="2">
                  <c:v>270.5910516666666</c:v>
                </c:pt>
                <c:pt idx="3">
                  <c:v>350.92215483333331</c:v>
                </c:pt>
                <c:pt idx="4">
                  <c:v>372.69886399999996</c:v>
                </c:pt>
                <c:pt idx="5">
                  <c:v>400.171967</c:v>
                </c:pt>
                <c:pt idx="6">
                  <c:v>434.41642716666667</c:v>
                </c:pt>
                <c:pt idx="7">
                  <c:v>518.67978400000004</c:v>
                </c:pt>
                <c:pt idx="8">
                  <c:v>552.31101229999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0988496"/>
        <c:axId val="-30986320"/>
      </c:scatterChart>
      <c:valAx>
        <c:axId val="-30988496"/>
        <c:scaling>
          <c:orientation val="minMax"/>
          <c:max val="3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ja-JP"/>
          </a:p>
        </c:txPr>
        <c:crossAx val="-30986320"/>
        <c:crosses val="autoZero"/>
        <c:crossBetween val="midCat"/>
        <c:majorUnit val="7"/>
      </c:valAx>
      <c:valAx>
        <c:axId val="-30986320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30988496"/>
        <c:crosses val="autoZero"/>
        <c:crossBetween val="midCat"/>
        <c:majorUnit val="300"/>
      </c:valAx>
    </c:plotArea>
    <c:legend>
      <c:legendPos val="r"/>
      <c:layout>
        <c:manualLayout>
          <c:xMode val="edge"/>
          <c:yMode val="edge"/>
          <c:x val="0.16647672166778818"/>
          <c:y val="7.62086732955643E-2"/>
          <c:w val="0.33702047772944249"/>
          <c:h val="0.32884496238787642"/>
        </c:manualLayout>
      </c:layout>
      <c:overlay val="0"/>
      <c:txPr>
        <a:bodyPr/>
        <a:lstStyle/>
        <a:p>
          <a:pPr>
            <a:defRPr sz="700">
              <a:latin typeface="Helvetica" panose="020B0604020202020204" pitchFamily="34" charset="0"/>
              <a:cs typeface="Helvetica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600" b="1"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2825462852576701E-2"/>
          <c:y val="0.10270065222633254"/>
          <c:w val="0.73988962646125744"/>
          <c:h val="0.73265189698470301"/>
        </c:manualLayout>
      </c:layout>
      <c:scatterChart>
        <c:scatterStyle val="lineMarker"/>
        <c:varyColors val="0"/>
        <c:ser>
          <c:idx val="0"/>
          <c:order val="0"/>
          <c:tx>
            <c:strRef>
              <c:f>'RPC-9'!$D$253</c:f>
              <c:strCache>
                <c:ptCount val="1"/>
                <c:pt idx="0">
                  <c:v>Vehicle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12:$U$212</c:f>
                <c:numCache>
                  <c:formatCode>General</c:formatCode>
                  <c:ptCount val="17"/>
                  <c:pt idx="0">
                    <c:v>0.43969686527576402</c:v>
                  </c:pt>
                  <c:pt idx="1">
                    <c:v>0.31721443851123787</c:v>
                  </c:pt>
                  <c:pt idx="2">
                    <c:v>0.21213203435596417</c:v>
                  </c:pt>
                  <c:pt idx="3">
                    <c:v>0.19311050377094122</c:v>
                  </c:pt>
                  <c:pt idx="4">
                    <c:v>0.21746647251166484</c:v>
                  </c:pt>
                  <c:pt idx="5">
                    <c:v>0.13149778198382936</c:v>
                  </c:pt>
                  <c:pt idx="6">
                    <c:v>0.20412414523193151</c:v>
                  </c:pt>
                  <c:pt idx="7">
                    <c:v>0.26575364531836621</c:v>
                  </c:pt>
                  <c:pt idx="8">
                    <c:v>0.29545163168726374</c:v>
                  </c:pt>
                  <c:pt idx="9">
                    <c:v>0.20207259421636889</c:v>
                  </c:pt>
                  <c:pt idx="10">
                    <c:v>0.22730302828309742</c:v>
                  </c:pt>
                  <c:pt idx="11">
                    <c:v>0.49223131418741184</c:v>
                  </c:pt>
                  <c:pt idx="12">
                    <c:v>0.4956056900399754</c:v>
                  </c:pt>
                  <c:pt idx="13">
                    <c:v>0.52041649986653338</c:v>
                  </c:pt>
                  <c:pt idx="14">
                    <c:v>1.1535271995059326</c:v>
                  </c:pt>
                  <c:pt idx="15">
                    <c:v>0.37969285832981742</c:v>
                  </c:pt>
                  <c:pt idx="16">
                    <c:v>0.540061724867322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52:$M$252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</c:numCache>
            </c:numRef>
          </c:xVal>
          <c:yVal>
            <c:numRef>
              <c:f>'RPC-9'!$E$253:$M$253</c:f>
              <c:numCache>
                <c:formatCode>General</c:formatCode>
                <c:ptCount val="9"/>
                <c:pt idx="0">
                  <c:v>20.6</c:v>
                </c:pt>
                <c:pt idx="1">
                  <c:v>20.975000000000001</c:v>
                </c:pt>
                <c:pt idx="2">
                  <c:v>21.299999999999997</c:v>
                </c:pt>
                <c:pt idx="3">
                  <c:v>20.725000000000001</c:v>
                </c:pt>
                <c:pt idx="4">
                  <c:v>20.625</c:v>
                </c:pt>
                <c:pt idx="5">
                  <c:v>20.875</c:v>
                </c:pt>
                <c:pt idx="6">
                  <c:v>21.1</c:v>
                </c:pt>
                <c:pt idx="7">
                  <c:v>20.975000000000001</c:v>
                </c:pt>
                <c:pt idx="8">
                  <c:v>21.22500000000000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RPC-9'!$D$254</c:f>
              <c:strCache>
                <c:ptCount val="1"/>
                <c:pt idx="0">
                  <c:v>Afa(10)</c:v>
                </c:pt>
              </c:strCache>
            </c:strRef>
          </c:tx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19:$U$219</c:f>
                <c:numCache>
                  <c:formatCode>General</c:formatCode>
                  <c:ptCount val="17"/>
                  <c:pt idx="0">
                    <c:v>0.58118652580542318</c:v>
                  </c:pt>
                  <c:pt idx="1">
                    <c:v>0.51961524227066347</c:v>
                  </c:pt>
                  <c:pt idx="2">
                    <c:v>0.17638342073763877</c:v>
                  </c:pt>
                  <c:pt idx="3">
                    <c:v>0.25166114784235838</c:v>
                  </c:pt>
                  <c:pt idx="4">
                    <c:v>0.58594652770823152</c:v>
                  </c:pt>
                  <c:pt idx="5">
                    <c:v>0.54569018479149589</c:v>
                  </c:pt>
                  <c:pt idx="6">
                    <c:v>0.67412494720522309</c:v>
                  </c:pt>
                  <c:pt idx="7">
                    <c:v>0.37859388972001734</c:v>
                  </c:pt>
                  <c:pt idx="8">
                    <c:v>0.5044248650140517</c:v>
                  </c:pt>
                  <c:pt idx="9">
                    <c:v>0.36055512754639862</c:v>
                  </c:pt>
                  <c:pt idx="10">
                    <c:v>0.77960103756843313</c:v>
                  </c:pt>
                  <c:pt idx="11">
                    <c:v>0.58118652580542329</c:v>
                  </c:pt>
                  <c:pt idx="12">
                    <c:v>0.25166114784235838</c:v>
                  </c:pt>
                  <c:pt idx="13">
                    <c:v>0.43333333333333363</c:v>
                  </c:pt>
                  <c:pt idx="14">
                    <c:v>0.44095855184409843</c:v>
                  </c:pt>
                  <c:pt idx="15">
                    <c:v>0.65064070986477152</c:v>
                  </c:pt>
                  <c:pt idx="16">
                    <c:v>0.5456901847914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52:$M$252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</c:numCache>
            </c:numRef>
          </c:xVal>
          <c:yVal>
            <c:numRef>
              <c:f>'RPC-9'!$E$254:$M$254</c:f>
              <c:numCache>
                <c:formatCode>General</c:formatCode>
                <c:ptCount val="9"/>
                <c:pt idx="0">
                  <c:v>21.333333333333332</c:v>
                </c:pt>
                <c:pt idx="1">
                  <c:v>21.3</c:v>
                </c:pt>
                <c:pt idx="2">
                  <c:v>22.066666666666666</c:v>
                </c:pt>
                <c:pt idx="3">
                  <c:v>20.5</c:v>
                </c:pt>
                <c:pt idx="4">
                  <c:v>20</c:v>
                </c:pt>
                <c:pt idx="5">
                  <c:v>20.166666666666668</c:v>
                </c:pt>
                <c:pt idx="6">
                  <c:v>20.266666666666666</c:v>
                </c:pt>
                <c:pt idx="7">
                  <c:v>20.7</c:v>
                </c:pt>
                <c:pt idx="8">
                  <c:v>21.966666666666669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RPC-9'!$D$255</c:f>
              <c:strCache>
                <c:ptCount val="1"/>
                <c:pt idx="0">
                  <c:v>Cet(0.1)</c:v>
                </c:pt>
              </c:strCache>
            </c:strRef>
          </c:tx>
          <c:spPr>
            <a:ln w="12700">
              <a:solidFill>
                <a:srgbClr val="7030A0"/>
              </a:solidFill>
              <a:prstDash val="sysDot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26:$U$226</c:f>
                <c:numCache>
                  <c:formatCode>General</c:formatCode>
                  <c:ptCount val="17"/>
                  <c:pt idx="0">
                    <c:v>0.61101009266077855</c:v>
                  </c:pt>
                  <c:pt idx="1">
                    <c:v>0.2081665999466131</c:v>
                  </c:pt>
                  <c:pt idx="2">
                    <c:v>0.37859388972001845</c:v>
                  </c:pt>
                  <c:pt idx="3">
                    <c:v>0.29627314724385295</c:v>
                  </c:pt>
                  <c:pt idx="4">
                    <c:v>0.21858128414339961</c:v>
                  </c:pt>
                  <c:pt idx="5">
                    <c:v>0.37859388972001845</c:v>
                  </c:pt>
                  <c:pt idx="6">
                    <c:v>0.43333333333333363</c:v>
                  </c:pt>
                  <c:pt idx="7">
                    <c:v>0.66583281184793852</c:v>
                  </c:pt>
                  <c:pt idx="8">
                    <c:v>0.49103066208854096</c:v>
                  </c:pt>
                  <c:pt idx="9">
                    <c:v>0.6119186583561933</c:v>
                  </c:pt>
                  <c:pt idx="10">
                    <c:v>0.46666666666666712</c:v>
                  </c:pt>
                  <c:pt idx="11">
                    <c:v>0.77960103756843313</c:v>
                  </c:pt>
                  <c:pt idx="12">
                    <c:v>0.64291005073286345</c:v>
                  </c:pt>
                  <c:pt idx="13">
                    <c:v>0.4163331998932262</c:v>
                  </c:pt>
                  <c:pt idx="14">
                    <c:v>0.19999999999999929</c:v>
                  </c:pt>
                  <c:pt idx="15">
                    <c:v>0.98206132417708192</c:v>
                  </c:pt>
                  <c:pt idx="16">
                    <c:v>0.850490054811537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52:$M$252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</c:numCache>
            </c:numRef>
          </c:xVal>
          <c:yVal>
            <c:numRef>
              <c:f>'RPC-9'!$E$255:$M$255</c:f>
              <c:numCache>
                <c:formatCode>General</c:formatCode>
                <c:ptCount val="9"/>
                <c:pt idx="0">
                  <c:v>21.3</c:v>
                </c:pt>
                <c:pt idx="1">
                  <c:v>21.000000000000004</c:v>
                </c:pt>
                <c:pt idx="2">
                  <c:v>21.900000000000002</c:v>
                </c:pt>
                <c:pt idx="3">
                  <c:v>21.833333333333332</c:v>
                </c:pt>
                <c:pt idx="4">
                  <c:v>21.766666666666666</c:v>
                </c:pt>
                <c:pt idx="5">
                  <c:v>21.7</c:v>
                </c:pt>
                <c:pt idx="6">
                  <c:v>22.166666666666668</c:v>
                </c:pt>
                <c:pt idx="7">
                  <c:v>22.3</c:v>
                </c:pt>
                <c:pt idx="8">
                  <c:v>22.366666666666664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RPC-9'!$D$256</c:f>
              <c:strCache>
                <c:ptCount val="1"/>
                <c:pt idx="0">
                  <c:v>Bev(2)</c:v>
                </c:pt>
              </c:strCache>
            </c:strRef>
          </c:tx>
          <c:spPr>
            <a:ln w="12700">
              <a:solidFill>
                <a:srgbClr val="C00000"/>
              </a:solidFill>
              <a:prstDash val="sysDash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33:$U$233</c:f>
                <c:numCache>
                  <c:formatCode>General</c:formatCode>
                  <c:ptCount val="17"/>
                  <c:pt idx="0">
                    <c:v>0.92915732431775677</c:v>
                  </c:pt>
                  <c:pt idx="1">
                    <c:v>0.43588989435406733</c:v>
                  </c:pt>
                  <c:pt idx="2">
                    <c:v>0.61734197258173806</c:v>
                  </c:pt>
                  <c:pt idx="3">
                    <c:v>0.72648315725677892</c:v>
                  </c:pt>
                  <c:pt idx="4">
                    <c:v>0.72188026092359059</c:v>
                  </c:pt>
                  <c:pt idx="5">
                    <c:v>0.68394281762277331</c:v>
                  </c:pt>
                  <c:pt idx="6">
                    <c:v>1.2991450179936719</c:v>
                  </c:pt>
                  <c:pt idx="7">
                    <c:v>1.5961759858416917</c:v>
                  </c:pt>
                  <c:pt idx="8">
                    <c:v>1.3576941236277538</c:v>
                  </c:pt>
                  <c:pt idx="9">
                    <c:v>1.2170090842352459</c:v>
                  </c:pt>
                  <c:pt idx="10">
                    <c:v>1.3383239933256494</c:v>
                  </c:pt>
                  <c:pt idx="11">
                    <c:v>1.4745997573729772</c:v>
                  </c:pt>
                  <c:pt idx="12">
                    <c:v>1.7333333333333432</c:v>
                  </c:pt>
                  <c:pt idx="13">
                    <c:v>1.6010413278030613</c:v>
                  </c:pt>
                  <c:pt idx="14">
                    <c:v>1.7521415467934942</c:v>
                  </c:pt>
                  <c:pt idx="15">
                    <c:v>1.6010413278030613</c:v>
                  </c:pt>
                  <c:pt idx="16">
                    <c:v>1.88885620886762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52:$M$252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</c:numCache>
            </c:numRef>
          </c:xVal>
          <c:yVal>
            <c:numRef>
              <c:f>'RPC-9'!$E$256:$M$256</c:f>
              <c:numCache>
                <c:formatCode>General</c:formatCode>
                <c:ptCount val="9"/>
                <c:pt idx="0">
                  <c:v>21.3</c:v>
                </c:pt>
                <c:pt idx="1">
                  <c:v>21.3</c:v>
                </c:pt>
                <c:pt idx="2">
                  <c:v>21.333333333333332</c:v>
                </c:pt>
                <c:pt idx="3">
                  <c:v>21.466666666666669</c:v>
                </c:pt>
                <c:pt idx="4">
                  <c:v>21.666666666666668</c:v>
                </c:pt>
                <c:pt idx="5">
                  <c:v>21.233333333333334</c:v>
                </c:pt>
                <c:pt idx="6">
                  <c:v>21.633333333333336</c:v>
                </c:pt>
                <c:pt idx="7">
                  <c:v>21.433333333333337</c:v>
                </c:pt>
                <c:pt idx="8">
                  <c:v>21.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06782080"/>
        <c:axId val="-306779904"/>
      </c:scatterChart>
      <c:valAx>
        <c:axId val="-306782080"/>
        <c:scaling>
          <c:orientation val="minMax"/>
          <c:max val="3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ja-JP"/>
          </a:p>
        </c:txPr>
        <c:crossAx val="-306779904"/>
        <c:crosses val="autoZero"/>
        <c:crossBetween val="midCat"/>
        <c:majorUnit val="7"/>
      </c:valAx>
      <c:valAx>
        <c:axId val="-306779904"/>
        <c:scaling>
          <c:orientation val="minMax"/>
          <c:max val="25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30678208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418056172770927"/>
          <c:y val="0.31639647473722715"/>
          <c:w val="0.29258187319160456"/>
          <c:h val="0.39258024665797081"/>
        </c:manualLayout>
      </c:layout>
      <c:overlay val="0"/>
      <c:txPr>
        <a:bodyPr/>
        <a:lstStyle/>
        <a:p>
          <a:pPr>
            <a:defRPr sz="700">
              <a:latin typeface="Helvetica" panose="020B0604020202020204" pitchFamily="34" charset="0"/>
              <a:cs typeface="Helvetica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600" b="1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22581344152633"/>
          <c:y val="9.6779333421083621E-2"/>
          <c:w val="0.85146180820234696"/>
          <c:h val="0.74806614524520432"/>
        </c:manualLayout>
      </c:layout>
      <c:scatterChart>
        <c:scatterStyle val="lineMarker"/>
        <c:varyColors val="0"/>
        <c:ser>
          <c:idx val="0"/>
          <c:order val="0"/>
          <c:tx>
            <c:strRef>
              <c:f>'RPC-9'!$D$247</c:f>
              <c:strCache>
                <c:ptCount val="1"/>
                <c:pt idx="0">
                  <c:v>Vehicle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193:$U$193</c:f>
                <c:numCache>
                  <c:formatCode>General</c:formatCode>
                  <c:ptCount val="17"/>
                  <c:pt idx="0">
                    <c:v>7.2342311787629905</c:v>
                  </c:pt>
                  <c:pt idx="1">
                    <c:v>17.408342205731977</c:v>
                  </c:pt>
                  <c:pt idx="2">
                    <c:v>24.515507649845588</c:v>
                  </c:pt>
                  <c:pt idx="3">
                    <c:v>48.748131623334274</c:v>
                  </c:pt>
                  <c:pt idx="4">
                    <c:v>53.684283254745331</c:v>
                  </c:pt>
                  <c:pt idx="5">
                    <c:v>64.160787221544794</c:v>
                  </c:pt>
                  <c:pt idx="6">
                    <c:v>94.708693050758299</c:v>
                  </c:pt>
                  <c:pt idx="7">
                    <c:v>103.21857974751403</c:v>
                  </c:pt>
                  <c:pt idx="8">
                    <c:v>97.307698122270494</c:v>
                  </c:pt>
                  <c:pt idx="9">
                    <c:v>113.8700168534352</c:v>
                  </c:pt>
                  <c:pt idx="10">
                    <c:v>106.78426407290704</c:v>
                  </c:pt>
                  <c:pt idx="11">
                    <c:v>101.55092027365734</c:v>
                  </c:pt>
                  <c:pt idx="12">
                    <c:v>103.37056812181891</c:v>
                  </c:pt>
                  <c:pt idx="13">
                    <c:v>96.883184761899926</c:v>
                  </c:pt>
                  <c:pt idx="14">
                    <c:v>118.07254791515076</c:v>
                  </c:pt>
                  <c:pt idx="15">
                    <c:v>85.879294142214547</c:v>
                  </c:pt>
                  <c:pt idx="16">
                    <c:v>149.704115873343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46:$U$246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47:$U$247</c:f>
              <c:numCache>
                <c:formatCode>General</c:formatCode>
                <c:ptCount val="17"/>
                <c:pt idx="0">
                  <c:v>148.15602750000002</c:v>
                </c:pt>
                <c:pt idx="1">
                  <c:v>263.61882912500005</c:v>
                </c:pt>
                <c:pt idx="2">
                  <c:v>461.79507512500004</c:v>
                </c:pt>
                <c:pt idx="3">
                  <c:v>715.33919193750012</c:v>
                </c:pt>
                <c:pt idx="4">
                  <c:v>820.15221525000004</c:v>
                </c:pt>
                <c:pt idx="5">
                  <c:v>979.80173231250012</c:v>
                </c:pt>
                <c:pt idx="6">
                  <c:v>1103.388117125</c:v>
                </c:pt>
                <c:pt idx="7">
                  <c:v>1204.2725539374999</c:v>
                </c:pt>
                <c:pt idx="8">
                  <c:v>1276.1135868125002</c:v>
                </c:pt>
                <c:pt idx="9">
                  <c:v>1317.3356069375002</c:v>
                </c:pt>
                <c:pt idx="10">
                  <c:v>1312.8417369374999</c:v>
                </c:pt>
                <c:pt idx="11">
                  <c:v>1371.1887081249999</c:v>
                </c:pt>
                <c:pt idx="12">
                  <c:v>1392.7795425000002</c:v>
                </c:pt>
                <c:pt idx="13">
                  <c:v>1462.2918305625003</c:v>
                </c:pt>
                <c:pt idx="14">
                  <c:v>1502.1575774375001</c:v>
                </c:pt>
                <c:pt idx="15">
                  <c:v>1526.2402169375002</c:v>
                </c:pt>
                <c:pt idx="16">
                  <c:v>1441.590471437499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RPC-9'!$D$248</c:f>
              <c:strCache>
                <c:ptCount val="1"/>
                <c:pt idx="0">
                  <c:v>Afa(10)/bev(2)</c:v>
                </c:pt>
              </c:strCache>
            </c:strRef>
          </c:tx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06:$U$206</c:f>
                <c:numCache>
                  <c:formatCode>General</c:formatCode>
                  <c:ptCount val="17"/>
                  <c:pt idx="0">
                    <c:v>7.4085136168358323</c:v>
                  </c:pt>
                  <c:pt idx="1">
                    <c:v>7.5884157487887753</c:v>
                  </c:pt>
                  <c:pt idx="2">
                    <c:v>11.729391862083657</c:v>
                  </c:pt>
                  <c:pt idx="3">
                    <c:v>29.454584166420869</c:v>
                  </c:pt>
                  <c:pt idx="4">
                    <c:v>35.152567549457018</c:v>
                  </c:pt>
                  <c:pt idx="5">
                    <c:v>34.300383796060068</c:v>
                  </c:pt>
                  <c:pt idx="6">
                    <c:v>32.392156095641482</c:v>
                  </c:pt>
                  <c:pt idx="7">
                    <c:v>38.501327259749246</c:v>
                  </c:pt>
                  <c:pt idx="8">
                    <c:v>35.310699059069222</c:v>
                  </c:pt>
                  <c:pt idx="9">
                    <c:v>36.861444894814362</c:v>
                  </c:pt>
                  <c:pt idx="10">
                    <c:v>41.699866089005624</c:v>
                  </c:pt>
                  <c:pt idx="11">
                    <c:v>49.779545871952848</c:v>
                  </c:pt>
                  <c:pt idx="12">
                    <c:v>58.89750096358641</c:v>
                  </c:pt>
                  <c:pt idx="13">
                    <c:v>55.394778161277515</c:v>
                  </c:pt>
                  <c:pt idx="14">
                    <c:v>60.684249240406331</c:v>
                  </c:pt>
                  <c:pt idx="15">
                    <c:v>76.624251811403084</c:v>
                  </c:pt>
                  <c:pt idx="16">
                    <c:v>100.174144349137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46:$U$246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48:$U$248</c:f>
              <c:numCache>
                <c:formatCode>General</c:formatCode>
                <c:ptCount val="17"/>
                <c:pt idx="0">
                  <c:v>156.26255706249998</c:v>
                </c:pt>
                <c:pt idx="1">
                  <c:v>174.81309600000003</c:v>
                </c:pt>
                <c:pt idx="2">
                  <c:v>201.99278743750003</c:v>
                </c:pt>
                <c:pt idx="3">
                  <c:v>289.97630856249992</c:v>
                </c:pt>
                <c:pt idx="4">
                  <c:v>340.45919037499999</c:v>
                </c:pt>
                <c:pt idx="5">
                  <c:v>380.57097006250001</c:v>
                </c:pt>
                <c:pt idx="6">
                  <c:v>395.68146293749999</c:v>
                </c:pt>
                <c:pt idx="7">
                  <c:v>427.56037224999994</c:v>
                </c:pt>
                <c:pt idx="8">
                  <c:v>427.56847725</c:v>
                </c:pt>
                <c:pt idx="9">
                  <c:v>494.72681956250005</c:v>
                </c:pt>
                <c:pt idx="10">
                  <c:v>512.47591924999983</c:v>
                </c:pt>
                <c:pt idx="11">
                  <c:v>519.20682425000007</c:v>
                </c:pt>
                <c:pt idx="12">
                  <c:v>542.86003318749999</c:v>
                </c:pt>
                <c:pt idx="13">
                  <c:v>518.20823656250002</c:v>
                </c:pt>
                <c:pt idx="14">
                  <c:v>567.79529250000007</c:v>
                </c:pt>
                <c:pt idx="15">
                  <c:v>620.16029206250005</c:v>
                </c:pt>
                <c:pt idx="16">
                  <c:v>732.5413528125000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RPC-9'!$D$249</c:f>
              <c:strCache>
                <c:ptCount val="1"/>
                <c:pt idx="0">
                  <c:v>Cet(0.1)/bev(2)</c:v>
                </c:pt>
              </c:strCache>
            </c:strRef>
          </c:tx>
          <c:spPr>
            <a:ln w="12700">
              <a:solidFill>
                <a:srgbClr val="7030A0"/>
              </a:solidFill>
              <a:prstDash val="sysDot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18:$U$218</c:f>
                <c:numCache>
                  <c:formatCode>General</c:formatCode>
                  <c:ptCount val="17"/>
                  <c:pt idx="0">
                    <c:v>7.1608479890440133</c:v>
                  </c:pt>
                  <c:pt idx="1">
                    <c:v>4.2327175391148533</c:v>
                  </c:pt>
                  <c:pt idx="2">
                    <c:v>4.8906127296240101</c:v>
                  </c:pt>
                  <c:pt idx="3">
                    <c:v>16.803095523769219</c:v>
                  </c:pt>
                  <c:pt idx="4">
                    <c:v>20.868320021999349</c:v>
                  </c:pt>
                  <c:pt idx="5">
                    <c:v>27.475049807417104</c:v>
                  </c:pt>
                  <c:pt idx="6">
                    <c:v>35.934735039073757</c:v>
                  </c:pt>
                  <c:pt idx="7">
                    <c:v>34.313113548046694</c:v>
                  </c:pt>
                  <c:pt idx="8">
                    <c:v>36.540458433235194</c:v>
                  </c:pt>
                  <c:pt idx="9">
                    <c:v>13.961379597535863</c:v>
                  </c:pt>
                  <c:pt idx="10">
                    <c:v>20.050780423192997</c:v>
                  </c:pt>
                  <c:pt idx="11">
                    <c:v>24.045422526215152</c:v>
                  </c:pt>
                  <c:pt idx="12">
                    <c:v>18.681979406050349</c:v>
                  </c:pt>
                  <c:pt idx="13">
                    <c:v>18.583549702574963</c:v>
                  </c:pt>
                  <c:pt idx="14">
                    <c:v>17.936821842244573</c:v>
                  </c:pt>
                  <c:pt idx="15">
                    <c:v>20.939381646259509</c:v>
                  </c:pt>
                  <c:pt idx="16">
                    <c:v>40.3603734399740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46:$U$246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49:$U$249</c:f>
              <c:numCache>
                <c:formatCode>General</c:formatCode>
                <c:ptCount val="17"/>
                <c:pt idx="0">
                  <c:v>131.46531537499999</c:v>
                </c:pt>
                <c:pt idx="1">
                  <c:v>135.2063701875</c:v>
                </c:pt>
                <c:pt idx="2">
                  <c:v>155.67660306250002</c:v>
                </c:pt>
                <c:pt idx="3">
                  <c:v>221.45808418749999</c:v>
                </c:pt>
                <c:pt idx="4">
                  <c:v>234.30769031249997</c:v>
                </c:pt>
                <c:pt idx="5">
                  <c:v>266.91343268749995</c:v>
                </c:pt>
                <c:pt idx="6">
                  <c:v>294.7084823125</c:v>
                </c:pt>
                <c:pt idx="7">
                  <c:v>322.23457224999999</c:v>
                </c:pt>
                <c:pt idx="8">
                  <c:v>345.44286212499992</c:v>
                </c:pt>
                <c:pt idx="9">
                  <c:v>362.37797775000001</c:v>
                </c:pt>
                <c:pt idx="10">
                  <c:v>377.61417812499997</c:v>
                </c:pt>
                <c:pt idx="11">
                  <c:v>400.47893131249998</c:v>
                </c:pt>
                <c:pt idx="12">
                  <c:v>411.98902718750003</c:v>
                </c:pt>
                <c:pt idx="13">
                  <c:v>433.79923006249999</c:v>
                </c:pt>
                <c:pt idx="14">
                  <c:v>502.88530093750001</c:v>
                </c:pt>
                <c:pt idx="15">
                  <c:v>578.04939375000004</c:v>
                </c:pt>
                <c:pt idx="16">
                  <c:v>632.220125625000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06780992"/>
        <c:axId val="-306776640"/>
      </c:scatterChart>
      <c:valAx>
        <c:axId val="-306780992"/>
        <c:scaling>
          <c:orientation val="minMax"/>
          <c:max val="5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306776640"/>
        <c:crosses val="autoZero"/>
        <c:crossBetween val="midCat"/>
        <c:majorUnit val="7"/>
      </c:valAx>
      <c:valAx>
        <c:axId val="-306776640"/>
        <c:scaling>
          <c:orientation val="minMax"/>
          <c:max val="180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306780992"/>
        <c:crosses val="autoZero"/>
        <c:crossBetween val="midCat"/>
        <c:majorUnit val="300"/>
      </c:valAx>
    </c:plotArea>
    <c:legend>
      <c:legendPos val="r"/>
      <c:layout>
        <c:manualLayout>
          <c:xMode val="edge"/>
          <c:yMode val="edge"/>
          <c:x val="0.12450170897345095"/>
          <c:y val="8.5471293422950314E-3"/>
          <c:w val="0.45236380112458879"/>
          <c:h val="0.24523858071306215"/>
        </c:manualLayout>
      </c:layout>
      <c:overlay val="0"/>
      <c:txPr>
        <a:bodyPr/>
        <a:lstStyle/>
        <a:p>
          <a:pPr>
            <a:defRPr sz="700">
              <a:latin typeface="Helvetica" panose="020B0604020202020204" pitchFamily="34" charset="0"/>
              <a:cs typeface="Helvetica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600" b="1"/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865952541833935"/>
          <c:y val="7.2395443978016741E-2"/>
          <c:w val="0.79635358549727331"/>
          <c:h val="0.78265090898635492"/>
        </c:manualLayout>
      </c:layout>
      <c:scatterChart>
        <c:scatterStyle val="lineMarker"/>
        <c:varyColors val="0"/>
        <c:ser>
          <c:idx val="0"/>
          <c:order val="0"/>
          <c:tx>
            <c:strRef>
              <c:f>'RPC-9'!$D$286</c:f>
              <c:strCache>
                <c:ptCount val="1"/>
                <c:pt idx="0">
                  <c:v>Vehicle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58:$U$258</c:f>
                <c:numCache>
                  <c:formatCode>General</c:formatCode>
                  <c:ptCount val="17"/>
                  <c:pt idx="0">
                    <c:v>0.38595120589698068</c:v>
                  </c:pt>
                  <c:pt idx="1">
                    <c:v>0.41833001326703734</c:v>
                  </c:pt>
                  <c:pt idx="2">
                    <c:v>0.45643546458763823</c:v>
                  </c:pt>
                  <c:pt idx="3">
                    <c:v>0.54524459343185305</c:v>
                  </c:pt>
                  <c:pt idx="4">
                    <c:v>0.58523499553598146</c:v>
                  </c:pt>
                  <c:pt idx="5">
                    <c:v>0.64855608855364255</c:v>
                  </c:pt>
                  <c:pt idx="6">
                    <c:v>0.50062460986251989</c:v>
                  </c:pt>
                  <c:pt idx="7">
                    <c:v>0.83765545820860388</c:v>
                  </c:pt>
                  <c:pt idx="8">
                    <c:v>0.89849411053532646</c:v>
                  </c:pt>
                  <c:pt idx="9">
                    <c:v>0.7553972464869062</c:v>
                  </c:pt>
                  <c:pt idx="10">
                    <c:v>0.77728158775740119</c:v>
                  </c:pt>
                  <c:pt idx="11">
                    <c:v>0.74888806462203272</c:v>
                  </c:pt>
                  <c:pt idx="12">
                    <c:v>0.69447222166668832</c:v>
                  </c:pt>
                  <c:pt idx="13">
                    <c:v>0.78142498040438968</c:v>
                  </c:pt>
                  <c:pt idx="14">
                    <c:v>0.80661329024508355</c:v>
                  </c:pt>
                  <c:pt idx="15">
                    <c:v>0.89663723619607361</c:v>
                  </c:pt>
                  <c:pt idx="16">
                    <c:v>0.56935636175129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85:$U$285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86:$U$286</c:f>
              <c:numCache>
                <c:formatCode>General</c:formatCode>
                <c:ptCount val="17"/>
                <c:pt idx="0">
                  <c:v>15.524999999999999</c:v>
                </c:pt>
                <c:pt idx="1">
                  <c:v>16.8</c:v>
                </c:pt>
                <c:pt idx="2">
                  <c:v>18.700000000000003</c:v>
                </c:pt>
                <c:pt idx="3">
                  <c:v>18.324999999999999</c:v>
                </c:pt>
                <c:pt idx="4">
                  <c:v>18.350000000000001</c:v>
                </c:pt>
                <c:pt idx="5">
                  <c:v>18.274999999999999</c:v>
                </c:pt>
                <c:pt idx="6">
                  <c:v>18.825000000000003</c:v>
                </c:pt>
                <c:pt idx="7">
                  <c:v>19</c:v>
                </c:pt>
                <c:pt idx="8">
                  <c:v>19.225000000000001</c:v>
                </c:pt>
                <c:pt idx="9">
                  <c:v>19.024999999999999</c:v>
                </c:pt>
                <c:pt idx="10">
                  <c:v>18.95</c:v>
                </c:pt>
                <c:pt idx="11">
                  <c:v>19.05</c:v>
                </c:pt>
                <c:pt idx="12">
                  <c:v>19.825000000000003</c:v>
                </c:pt>
                <c:pt idx="13">
                  <c:v>20.074999999999999</c:v>
                </c:pt>
                <c:pt idx="14">
                  <c:v>19.524999999999999</c:v>
                </c:pt>
                <c:pt idx="15">
                  <c:v>19.225000000000001</c:v>
                </c:pt>
                <c:pt idx="16">
                  <c:v>20.4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RPC-9'!$D$287</c:f>
              <c:strCache>
                <c:ptCount val="1"/>
                <c:pt idx="0">
                  <c:v>Afa(10)/bev(2)</c:v>
                </c:pt>
              </c:strCache>
            </c:strRef>
          </c:tx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66:$U$266</c:f>
                <c:numCache>
                  <c:formatCode>General</c:formatCode>
                  <c:ptCount val="17"/>
                  <c:pt idx="0">
                    <c:v>0.30822070014844904</c:v>
                  </c:pt>
                  <c:pt idx="1">
                    <c:v>0.35207716957129326</c:v>
                  </c:pt>
                  <c:pt idx="2">
                    <c:v>0.47434164902525711</c:v>
                  </c:pt>
                  <c:pt idx="3">
                    <c:v>0.27233557730613595</c:v>
                  </c:pt>
                  <c:pt idx="4">
                    <c:v>0.33291640592396976</c:v>
                  </c:pt>
                  <c:pt idx="5">
                    <c:v>0.40078048854703513</c:v>
                  </c:pt>
                  <c:pt idx="6">
                    <c:v>0.39869579046352321</c:v>
                  </c:pt>
                  <c:pt idx="7">
                    <c:v>0.37052890125692822</c:v>
                  </c:pt>
                  <c:pt idx="8">
                    <c:v>0.41104541517128446</c:v>
                  </c:pt>
                  <c:pt idx="9">
                    <c:v>0.41508031351374242</c:v>
                  </c:pt>
                  <c:pt idx="10">
                    <c:v>0.38078865529319533</c:v>
                  </c:pt>
                  <c:pt idx="11">
                    <c:v>0.4743416490252565</c:v>
                  </c:pt>
                  <c:pt idx="12">
                    <c:v>0.36142080737002386</c:v>
                  </c:pt>
                  <c:pt idx="13">
                    <c:v>0.29825883613622095</c:v>
                  </c:pt>
                  <c:pt idx="14">
                    <c:v>0.51051444641655352</c:v>
                  </c:pt>
                  <c:pt idx="15">
                    <c:v>0.48131763593978849</c:v>
                  </c:pt>
                  <c:pt idx="16">
                    <c:v>0.6485560885536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85:$U$285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87:$U$287</c:f>
              <c:numCache>
                <c:formatCode>General</c:formatCode>
                <c:ptCount val="17"/>
                <c:pt idx="0">
                  <c:v>15.2</c:v>
                </c:pt>
                <c:pt idx="1">
                  <c:v>16.225000000000001</c:v>
                </c:pt>
                <c:pt idx="2">
                  <c:v>18.100000000000001</c:v>
                </c:pt>
                <c:pt idx="3">
                  <c:v>17.649999999999999</c:v>
                </c:pt>
                <c:pt idx="4">
                  <c:v>17.349999999999998</c:v>
                </c:pt>
                <c:pt idx="5">
                  <c:v>17.875</c:v>
                </c:pt>
                <c:pt idx="6">
                  <c:v>17.774999999999999</c:v>
                </c:pt>
                <c:pt idx="7">
                  <c:v>18.475000000000001</c:v>
                </c:pt>
                <c:pt idx="8">
                  <c:v>18.425000000000001</c:v>
                </c:pt>
                <c:pt idx="9">
                  <c:v>18.525000000000002</c:v>
                </c:pt>
                <c:pt idx="10">
                  <c:v>18.600000000000001</c:v>
                </c:pt>
                <c:pt idx="11">
                  <c:v>18.600000000000001</c:v>
                </c:pt>
                <c:pt idx="12">
                  <c:v>18.975000000000001</c:v>
                </c:pt>
                <c:pt idx="13">
                  <c:v>19.524999999999999</c:v>
                </c:pt>
                <c:pt idx="14">
                  <c:v>19.325000000000003</c:v>
                </c:pt>
                <c:pt idx="15">
                  <c:v>19.400000000000002</c:v>
                </c:pt>
                <c:pt idx="16">
                  <c:v>20.17500000000000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RPC-9'!$D$288</c:f>
              <c:strCache>
                <c:ptCount val="1"/>
                <c:pt idx="0">
                  <c:v>Cet(0.1)/bev(2)</c:v>
                </c:pt>
              </c:strCache>
            </c:strRef>
          </c:tx>
          <c:spPr>
            <a:ln w="12700">
              <a:solidFill>
                <a:srgbClr val="7030A0"/>
              </a:solidFill>
              <a:prstDash val="sysDot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74:$U$274</c:f>
                <c:numCache>
                  <c:formatCode>General</c:formatCode>
                  <c:ptCount val="17"/>
                  <c:pt idx="0">
                    <c:v>0.23935677693908461</c:v>
                  </c:pt>
                  <c:pt idx="1">
                    <c:v>0.36628768293059843</c:v>
                  </c:pt>
                  <c:pt idx="2">
                    <c:v>0.35910769044025381</c:v>
                  </c:pt>
                  <c:pt idx="3">
                    <c:v>0.38944404818493078</c:v>
                  </c:pt>
                  <c:pt idx="4">
                    <c:v>0.27233557730613622</c:v>
                  </c:pt>
                  <c:pt idx="5">
                    <c:v>0.21015867021530793</c:v>
                  </c:pt>
                  <c:pt idx="6">
                    <c:v>6.291528696058965E-2</c:v>
                  </c:pt>
                  <c:pt idx="7">
                    <c:v>0.19311050377094122</c:v>
                  </c:pt>
                  <c:pt idx="8">
                    <c:v>0.39024564913226989</c:v>
                  </c:pt>
                  <c:pt idx="9">
                    <c:v>0.54006172486732162</c:v>
                  </c:pt>
                  <c:pt idx="10">
                    <c:v>0.62232762004161979</c:v>
                  </c:pt>
                  <c:pt idx="11">
                    <c:v>0.3837859646556484</c:v>
                  </c:pt>
                  <c:pt idx="12">
                    <c:v>0.30822070014844927</c:v>
                  </c:pt>
                  <c:pt idx="13">
                    <c:v>8.5391256382996217E-2</c:v>
                  </c:pt>
                  <c:pt idx="14">
                    <c:v>0.22173557826083432</c:v>
                  </c:pt>
                  <c:pt idx="15">
                    <c:v>0.30923292192132429</c:v>
                  </c:pt>
                  <c:pt idx="16">
                    <c:v>0.6342646661029344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85:$U$285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88:$U$288</c:f>
              <c:numCache>
                <c:formatCode>General</c:formatCode>
                <c:ptCount val="17"/>
                <c:pt idx="0">
                  <c:v>16.175000000000001</c:v>
                </c:pt>
                <c:pt idx="1">
                  <c:v>17.149999999999999</c:v>
                </c:pt>
                <c:pt idx="2">
                  <c:v>18.425000000000001</c:v>
                </c:pt>
                <c:pt idx="3">
                  <c:v>17.899999999999999</c:v>
                </c:pt>
                <c:pt idx="4">
                  <c:v>18.45</c:v>
                </c:pt>
                <c:pt idx="5">
                  <c:v>18.75</c:v>
                </c:pt>
                <c:pt idx="6">
                  <c:v>19.125</c:v>
                </c:pt>
                <c:pt idx="7">
                  <c:v>19.125</c:v>
                </c:pt>
                <c:pt idx="8">
                  <c:v>19.324999999999999</c:v>
                </c:pt>
                <c:pt idx="9">
                  <c:v>19.400000000000002</c:v>
                </c:pt>
                <c:pt idx="10">
                  <c:v>19.524999999999999</c:v>
                </c:pt>
                <c:pt idx="11">
                  <c:v>19.424999999999997</c:v>
                </c:pt>
                <c:pt idx="12">
                  <c:v>20.399999999999999</c:v>
                </c:pt>
                <c:pt idx="13">
                  <c:v>20.824999999999999</c:v>
                </c:pt>
                <c:pt idx="14">
                  <c:v>21.15</c:v>
                </c:pt>
                <c:pt idx="15">
                  <c:v>21.975000000000001</c:v>
                </c:pt>
                <c:pt idx="16">
                  <c:v>22.1750000000000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06779360"/>
        <c:axId val="-306778816"/>
      </c:scatterChart>
      <c:valAx>
        <c:axId val="-306779360"/>
        <c:scaling>
          <c:orientation val="minMax"/>
          <c:max val="5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ja-JP"/>
          </a:p>
        </c:txPr>
        <c:crossAx val="-306778816"/>
        <c:crosses val="autoZero"/>
        <c:crossBetween val="midCat"/>
        <c:majorUnit val="7"/>
      </c:valAx>
      <c:valAx>
        <c:axId val="-30677881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ja-JP"/>
          </a:p>
        </c:txPr>
        <c:crossAx val="-30677936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7981725607677512"/>
          <c:y val="0.45969197866903677"/>
          <c:w val="0.53000746226354289"/>
          <c:h val="0.31973993630337372"/>
        </c:manualLayout>
      </c:layout>
      <c:overlay val="0"/>
      <c:txPr>
        <a:bodyPr/>
        <a:lstStyle/>
        <a:p>
          <a:pPr>
            <a:defRPr sz="700">
              <a:latin typeface="Helvetica" panose="020B0604020202020204" pitchFamily="34" charset="0"/>
              <a:cs typeface="Helvetica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600" b="1"/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154954832470342"/>
          <c:y val="8.799312683607706E-2"/>
          <c:w val="0.81936536724243558"/>
          <c:h val="0.77093820703138782"/>
        </c:manualLayout>
      </c:layout>
      <c:scatterChart>
        <c:scatterStyle val="lineMarker"/>
        <c:varyColors val="0"/>
        <c:ser>
          <c:idx val="0"/>
          <c:order val="0"/>
          <c:tx>
            <c:strRef>
              <c:f>'RPC-9'!$D$240</c:f>
              <c:strCache>
                <c:ptCount val="1"/>
                <c:pt idx="0">
                  <c:v>Vehicle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152:$U$152</c:f>
                <c:numCache>
                  <c:formatCode>General</c:formatCode>
                  <c:ptCount val="17"/>
                  <c:pt idx="0">
                    <c:v>21.785904855873156</c:v>
                  </c:pt>
                  <c:pt idx="1">
                    <c:v>45.84663824040134</c:v>
                  </c:pt>
                  <c:pt idx="2">
                    <c:v>74.4805266653877</c:v>
                  </c:pt>
                  <c:pt idx="3">
                    <c:v>86.622585707813656</c:v>
                  </c:pt>
                  <c:pt idx="4">
                    <c:v>110.34616005225388</c:v>
                  </c:pt>
                  <c:pt idx="5">
                    <c:v>111.25431592834775</c:v>
                  </c:pt>
                  <c:pt idx="6">
                    <c:v>142.41267239417698</c:v>
                  </c:pt>
                  <c:pt idx="7">
                    <c:v>148.83606318040938</c:v>
                  </c:pt>
                  <c:pt idx="8">
                    <c:v>159.34215812525377</c:v>
                  </c:pt>
                  <c:pt idx="9">
                    <c:v>178.7993509505863</c:v>
                  </c:pt>
                  <c:pt idx="10">
                    <c:v>194.78809827608583</c:v>
                  </c:pt>
                  <c:pt idx="11">
                    <c:v>211.83029083001946</c:v>
                  </c:pt>
                  <c:pt idx="12">
                    <c:v>213.09465825222398</c:v>
                  </c:pt>
                  <c:pt idx="13">
                    <c:v>226.98931814307718</c:v>
                  </c:pt>
                  <c:pt idx="14">
                    <c:v>228.19318846826965</c:v>
                  </c:pt>
                  <c:pt idx="15">
                    <c:v>229.53890228931704</c:v>
                  </c:pt>
                  <c:pt idx="16">
                    <c:v>260.526247677708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39:$U$239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40:$U$240</c:f>
              <c:numCache>
                <c:formatCode>General</c:formatCode>
                <c:ptCount val="17"/>
                <c:pt idx="0">
                  <c:v>144.86319758333332</c:v>
                </c:pt>
                <c:pt idx="1">
                  <c:v>194.26465899999997</c:v>
                </c:pt>
                <c:pt idx="2">
                  <c:v>249.29246608333324</c:v>
                </c:pt>
                <c:pt idx="3">
                  <c:v>332.37171333333333</c:v>
                </c:pt>
                <c:pt idx="4">
                  <c:v>378.13157766666671</c:v>
                </c:pt>
                <c:pt idx="5">
                  <c:v>431.08637025000002</c:v>
                </c:pt>
                <c:pt idx="6">
                  <c:v>491.06720433333339</c:v>
                </c:pt>
                <c:pt idx="7">
                  <c:v>563.87670649999995</c:v>
                </c:pt>
                <c:pt idx="8">
                  <c:v>637.56954758333325</c:v>
                </c:pt>
                <c:pt idx="9">
                  <c:v>707.62998216666665</c:v>
                </c:pt>
                <c:pt idx="10">
                  <c:v>761.50214291666668</c:v>
                </c:pt>
                <c:pt idx="11">
                  <c:v>839.27335075000008</c:v>
                </c:pt>
                <c:pt idx="12">
                  <c:v>905.97532966666665</c:v>
                </c:pt>
                <c:pt idx="13">
                  <c:v>1010.0553539166667</c:v>
                </c:pt>
                <c:pt idx="14">
                  <c:v>1032.0429999999999</c:v>
                </c:pt>
                <c:pt idx="15">
                  <c:v>1069.2909983333332</c:v>
                </c:pt>
                <c:pt idx="16">
                  <c:v>1142.782269833333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RPC-9'!$D$241</c:f>
              <c:strCache>
                <c:ptCount val="1"/>
                <c:pt idx="0">
                  <c:v>Afa(10)/cet(0.1)</c:v>
                </c:pt>
              </c:strCache>
            </c:strRef>
          </c:tx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177:$U$177</c:f>
                <c:numCache>
                  <c:formatCode>General</c:formatCode>
                  <c:ptCount val="17"/>
                  <c:pt idx="0">
                    <c:v>13.245030192101904</c:v>
                  </c:pt>
                  <c:pt idx="1">
                    <c:v>17.472086680366704</c:v>
                  </c:pt>
                  <c:pt idx="2">
                    <c:v>27.742081367331775</c:v>
                  </c:pt>
                  <c:pt idx="3">
                    <c:v>33.227727341042424</c:v>
                  </c:pt>
                  <c:pt idx="4">
                    <c:v>41.17756915938746</c:v>
                  </c:pt>
                  <c:pt idx="5">
                    <c:v>53.153228329023634</c:v>
                  </c:pt>
                  <c:pt idx="6">
                    <c:v>60.7138642316568</c:v>
                  </c:pt>
                  <c:pt idx="7">
                    <c:v>74.786782245037884</c:v>
                  </c:pt>
                  <c:pt idx="8">
                    <c:v>109.54268416681633</c:v>
                  </c:pt>
                  <c:pt idx="9">
                    <c:v>150.68412594274966</c:v>
                  </c:pt>
                  <c:pt idx="10">
                    <c:v>127.19155673343022</c:v>
                  </c:pt>
                  <c:pt idx="11">
                    <c:v>148.75501293886558</c:v>
                  </c:pt>
                  <c:pt idx="12">
                    <c:v>162.92971419791149</c:v>
                  </c:pt>
                  <c:pt idx="13">
                    <c:v>169.97407177964593</c:v>
                  </c:pt>
                  <c:pt idx="14">
                    <c:v>190.75132444792618</c:v>
                  </c:pt>
                  <c:pt idx="15">
                    <c:v>212.34302905305847</c:v>
                  </c:pt>
                  <c:pt idx="16">
                    <c:v>215.600786114837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39:$U$239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41:$U$241</c:f>
              <c:numCache>
                <c:formatCode>General</c:formatCode>
                <c:ptCount val="17"/>
                <c:pt idx="0">
                  <c:v>154.59107624999999</c:v>
                </c:pt>
                <c:pt idx="1">
                  <c:v>181.28662187500001</c:v>
                </c:pt>
                <c:pt idx="2">
                  <c:v>192.14136075000002</c:v>
                </c:pt>
                <c:pt idx="3">
                  <c:v>176.69950087499998</c:v>
                </c:pt>
                <c:pt idx="4">
                  <c:v>175.47773050000001</c:v>
                </c:pt>
                <c:pt idx="5">
                  <c:v>192.01340437499999</c:v>
                </c:pt>
                <c:pt idx="6">
                  <c:v>218.54907187500001</c:v>
                </c:pt>
                <c:pt idx="7">
                  <c:v>215.2407249375</c:v>
                </c:pt>
                <c:pt idx="8">
                  <c:v>268.13102681250001</c:v>
                </c:pt>
                <c:pt idx="9">
                  <c:v>347.98032212499999</c:v>
                </c:pt>
                <c:pt idx="10">
                  <c:v>333.98301118749998</c:v>
                </c:pt>
                <c:pt idx="11">
                  <c:v>390.37170674999999</c:v>
                </c:pt>
                <c:pt idx="12">
                  <c:v>444.4253285625</c:v>
                </c:pt>
                <c:pt idx="13">
                  <c:v>487.79093556250001</c:v>
                </c:pt>
                <c:pt idx="14">
                  <c:v>516.80413431249997</c:v>
                </c:pt>
                <c:pt idx="15">
                  <c:v>457.84099306249999</c:v>
                </c:pt>
                <c:pt idx="16">
                  <c:v>545.1075603125000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06777728"/>
        <c:axId val="-306783712"/>
      </c:scatterChart>
      <c:valAx>
        <c:axId val="-306777728"/>
        <c:scaling>
          <c:orientation val="minMax"/>
          <c:max val="5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306783712"/>
        <c:crosses val="autoZero"/>
        <c:crossBetween val="midCat"/>
        <c:majorUnit val="7"/>
      </c:valAx>
      <c:valAx>
        <c:axId val="-30678371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306777728"/>
        <c:crosses val="autoZero"/>
        <c:crossBetween val="midCat"/>
        <c:majorUnit val="300"/>
      </c:valAx>
    </c:plotArea>
    <c:legend>
      <c:legendPos val="r"/>
      <c:layout>
        <c:manualLayout>
          <c:xMode val="edge"/>
          <c:yMode val="edge"/>
          <c:x val="0.12078493038997266"/>
          <c:y val="8.8004464533164045E-2"/>
          <c:w val="0.45026355742020274"/>
          <c:h val="0.20003980791421644"/>
        </c:manualLayout>
      </c:layout>
      <c:overlay val="0"/>
      <c:txPr>
        <a:bodyPr/>
        <a:lstStyle/>
        <a:p>
          <a:pPr>
            <a:defRPr sz="700">
              <a:latin typeface="Helvetica" panose="020B0604020202020204" pitchFamily="34" charset="0"/>
              <a:cs typeface="Helvetica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600" b="1"/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1988407699037624E-2"/>
          <c:y val="5.1400554097404488E-2"/>
          <c:w val="0.89745603674540686"/>
          <c:h val="0.84568277923592883"/>
        </c:manualLayout>
      </c:layout>
      <c:scatterChart>
        <c:scatterStyle val="lineMarker"/>
        <c:varyColors val="0"/>
        <c:ser>
          <c:idx val="0"/>
          <c:order val="0"/>
          <c:tx>
            <c:strRef>
              <c:f>'RPC-9'!$D$245</c:f>
              <c:strCache>
                <c:ptCount val="1"/>
                <c:pt idx="0">
                  <c:v>Vehicle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04:$U$204</c:f>
                <c:numCache>
                  <c:formatCode>General</c:formatCode>
                  <c:ptCount val="17"/>
                  <c:pt idx="0">
                    <c:v>6.666666666666643E-2</c:v>
                  </c:pt>
                  <c:pt idx="1">
                    <c:v>0.13333333333333286</c:v>
                  </c:pt>
                  <c:pt idx="2">
                    <c:v>0.68068592855540488</c:v>
                  </c:pt>
                  <c:pt idx="3">
                    <c:v>0.60277137733417119</c:v>
                  </c:pt>
                  <c:pt idx="4">
                    <c:v>0.28480012484391826</c:v>
                  </c:pt>
                  <c:pt idx="5">
                    <c:v>0.53333333333333388</c:v>
                  </c:pt>
                  <c:pt idx="6">
                    <c:v>0.78810602783579242</c:v>
                  </c:pt>
                  <c:pt idx="7">
                    <c:v>0.86858761471969204</c:v>
                  </c:pt>
                  <c:pt idx="8">
                    <c:v>0.63857480202226702</c:v>
                  </c:pt>
                  <c:pt idx="9">
                    <c:v>0.36666666666666597</c:v>
                  </c:pt>
                  <c:pt idx="10">
                    <c:v>3.3333333333333812E-2</c:v>
                  </c:pt>
                  <c:pt idx="11">
                    <c:v>0.17638342073763877</c:v>
                  </c:pt>
                  <c:pt idx="12">
                    <c:v>0.26034165586355479</c:v>
                  </c:pt>
                  <c:pt idx="13">
                    <c:v>0.46666666666666706</c:v>
                  </c:pt>
                  <c:pt idx="14">
                    <c:v>0.31797973380564831</c:v>
                  </c:pt>
                  <c:pt idx="15">
                    <c:v>0.44845413490245689</c:v>
                  </c:pt>
                  <c:pt idx="16">
                    <c:v>0.600925212577331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44:$U$244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45:$U$245</c:f>
              <c:numCache>
                <c:formatCode>General</c:formatCode>
                <c:ptCount val="17"/>
                <c:pt idx="0">
                  <c:v>21.366666666666664</c:v>
                </c:pt>
                <c:pt idx="1">
                  <c:v>21.733333333333334</c:v>
                </c:pt>
                <c:pt idx="2">
                  <c:v>21</c:v>
                </c:pt>
                <c:pt idx="3">
                  <c:v>21.599999999999998</c:v>
                </c:pt>
                <c:pt idx="4">
                  <c:v>22.233333333333334</c:v>
                </c:pt>
                <c:pt idx="5">
                  <c:v>22.433333333333334</c:v>
                </c:pt>
                <c:pt idx="6">
                  <c:v>22.166666666666668</c:v>
                </c:pt>
                <c:pt idx="7">
                  <c:v>21.833333333333332</c:v>
                </c:pt>
                <c:pt idx="8">
                  <c:v>22.366666666666664</c:v>
                </c:pt>
                <c:pt idx="9">
                  <c:v>22.333333333333332</c:v>
                </c:pt>
                <c:pt idx="10">
                  <c:v>22.733333333333334</c:v>
                </c:pt>
                <c:pt idx="11">
                  <c:v>22.866666666666664</c:v>
                </c:pt>
                <c:pt idx="12">
                  <c:v>22.933333333333334</c:v>
                </c:pt>
                <c:pt idx="13">
                  <c:v>23.266666666666666</c:v>
                </c:pt>
                <c:pt idx="14">
                  <c:v>23.933333333333334</c:v>
                </c:pt>
                <c:pt idx="15">
                  <c:v>23.666666666666668</c:v>
                </c:pt>
                <c:pt idx="16">
                  <c:v>24.73333333333333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RPC-9'!$D$246</c:f>
              <c:strCache>
                <c:ptCount val="1"/>
                <c:pt idx="0">
                  <c:v>Afa(10)/cet(0.1)</c:v>
                </c:pt>
              </c:strCache>
            </c:strRef>
          </c:tx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20:$U$220</c:f>
                <c:numCache>
                  <c:formatCode>General</c:formatCode>
                  <c:ptCount val="17"/>
                  <c:pt idx="0">
                    <c:v>0.54006172486732174</c:v>
                  </c:pt>
                  <c:pt idx="1">
                    <c:v>0.58363087649643786</c:v>
                  </c:pt>
                  <c:pt idx="2">
                    <c:v>0.7359800721939872</c:v>
                  </c:pt>
                  <c:pt idx="3">
                    <c:v>0.71922991224410759</c:v>
                  </c:pt>
                  <c:pt idx="4">
                    <c:v>0.74204110398279111</c:v>
                  </c:pt>
                  <c:pt idx="5">
                    <c:v>0.74428377204755258</c:v>
                  </c:pt>
                  <c:pt idx="6">
                    <c:v>0.75111028928291701</c:v>
                  </c:pt>
                  <c:pt idx="7">
                    <c:v>0.85865689694235048</c:v>
                  </c:pt>
                  <c:pt idx="8">
                    <c:v>0.87309316035957285</c:v>
                  </c:pt>
                  <c:pt idx="9">
                    <c:v>0.84397373576828005</c:v>
                  </c:pt>
                  <c:pt idx="10">
                    <c:v>1.074709263010234</c:v>
                  </c:pt>
                  <c:pt idx="11">
                    <c:v>0.98858063235462335</c:v>
                  </c:pt>
                  <c:pt idx="12">
                    <c:v>1.095825411885184</c:v>
                  </c:pt>
                  <c:pt idx="13">
                    <c:v>1.0601690116831999</c:v>
                  </c:pt>
                  <c:pt idx="14">
                    <c:v>1.2196310917650472</c:v>
                  </c:pt>
                  <c:pt idx="15">
                    <c:v>1.3912674077976379</c:v>
                  </c:pt>
                  <c:pt idx="16">
                    <c:v>1.15686357593855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44:$U$244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46:$U$246</c:f>
              <c:numCache>
                <c:formatCode>General</c:formatCode>
                <c:ptCount val="17"/>
                <c:pt idx="0">
                  <c:v>20.5</c:v>
                </c:pt>
                <c:pt idx="1">
                  <c:v>20.225000000000001</c:v>
                </c:pt>
                <c:pt idx="2">
                  <c:v>20.100000000000001</c:v>
                </c:pt>
                <c:pt idx="3">
                  <c:v>19.125</c:v>
                </c:pt>
                <c:pt idx="4">
                  <c:v>19.774999999999999</c:v>
                </c:pt>
                <c:pt idx="5">
                  <c:v>20.675000000000001</c:v>
                </c:pt>
                <c:pt idx="6">
                  <c:v>20.75</c:v>
                </c:pt>
                <c:pt idx="7">
                  <c:v>20.824999999999999</c:v>
                </c:pt>
                <c:pt idx="8">
                  <c:v>21.125</c:v>
                </c:pt>
                <c:pt idx="9">
                  <c:v>21.425000000000001</c:v>
                </c:pt>
                <c:pt idx="10">
                  <c:v>21.6</c:v>
                </c:pt>
                <c:pt idx="11">
                  <c:v>21.824999999999999</c:v>
                </c:pt>
                <c:pt idx="12">
                  <c:v>21.75</c:v>
                </c:pt>
                <c:pt idx="13">
                  <c:v>21.974999999999998</c:v>
                </c:pt>
                <c:pt idx="14">
                  <c:v>22.45</c:v>
                </c:pt>
                <c:pt idx="15">
                  <c:v>22.725000000000001</c:v>
                </c:pt>
                <c:pt idx="16">
                  <c:v>23.8000000000000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83827440"/>
        <c:axId val="-283825808"/>
      </c:scatterChart>
      <c:valAx>
        <c:axId val="-283827440"/>
        <c:scaling>
          <c:orientation val="minMax"/>
          <c:max val="5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283825808"/>
        <c:crosses val="autoZero"/>
        <c:crossBetween val="midCat"/>
        <c:majorUnit val="7"/>
      </c:valAx>
      <c:valAx>
        <c:axId val="-283825808"/>
        <c:scaling>
          <c:orientation val="minMax"/>
          <c:max val="25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28382744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0916415753977252"/>
          <c:y val="0.45307223944883029"/>
          <c:w val="0.47522829573124603"/>
          <c:h val="0.34793048011657429"/>
        </c:manualLayout>
      </c:layout>
      <c:overlay val="0"/>
      <c:txPr>
        <a:bodyPr/>
        <a:lstStyle/>
        <a:p>
          <a:pPr>
            <a:defRPr sz="700">
              <a:latin typeface="Helvetica" panose="020B0604020202020204" pitchFamily="34" charset="0"/>
              <a:cs typeface="Helvetica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600" b="1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28863" y="1776341"/>
            <a:ext cx="4860449" cy="1225701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857726" y="3240299"/>
            <a:ext cx="4002723" cy="146131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267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53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801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068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335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960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870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6137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145677" y="228993"/>
            <a:ext cx="1286589" cy="487898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85909" y="228993"/>
            <a:ext cx="3764465" cy="487898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1696" y="3674457"/>
            <a:ext cx="4860449" cy="1135693"/>
          </a:xfrm>
        </p:spPr>
        <p:txBody>
          <a:bodyPr anchor="t"/>
          <a:lstStyle>
            <a:lvl1pPr algn="l">
              <a:defRPr sz="29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1696" y="2423607"/>
            <a:ext cx="4860449" cy="1250850"/>
          </a:xfrm>
        </p:spPr>
        <p:txBody>
          <a:bodyPr anchor="b"/>
          <a:lstStyle>
            <a:lvl1pPr marL="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1pPr>
            <a:lvl2pPr marL="32671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5343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3pPr>
            <a:lvl4pPr marL="98014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0686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3357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196029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28700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61372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85909" y="1334241"/>
            <a:ext cx="2525527" cy="3773731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906739" y="1334241"/>
            <a:ext cx="2525527" cy="3773731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85909" y="1279972"/>
            <a:ext cx="2526520" cy="533431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6715" indent="0">
              <a:buNone/>
              <a:defRPr sz="1400" b="1"/>
            </a:lvl2pPr>
            <a:lvl3pPr marL="653430" indent="0">
              <a:buNone/>
              <a:defRPr sz="1300" b="1"/>
            </a:lvl3pPr>
            <a:lvl4pPr marL="980145" indent="0">
              <a:buNone/>
              <a:defRPr sz="1100" b="1"/>
            </a:lvl4pPr>
            <a:lvl5pPr marL="1306860" indent="0">
              <a:buNone/>
              <a:defRPr sz="1100" b="1"/>
            </a:lvl5pPr>
            <a:lvl6pPr marL="1633576" indent="0">
              <a:buNone/>
              <a:defRPr sz="1100" b="1"/>
            </a:lvl6pPr>
            <a:lvl7pPr marL="1960291" indent="0">
              <a:buNone/>
              <a:defRPr sz="1100" b="1"/>
            </a:lvl7pPr>
            <a:lvl8pPr marL="2287006" indent="0">
              <a:buNone/>
              <a:defRPr sz="1100" b="1"/>
            </a:lvl8pPr>
            <a:lvl9pPr marL="2613721" indent="0">
              <a:buNone/>
              <a:defRPr sz="11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85909" y="1813403"/>
            <a:ext cx="2526520" cy="3294569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3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2904754" y="1279972"/>
            <a:ext cx="2527513" cy="533431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6715" indent="0">
              <a:buNone/>
              <a:defRPr sz="1400" b="1"/>
            </a:lvl2pPr>
            <a:lvl3pPr marL="653430" indent="0">
              <a:buNone/>
              <a:defRPr sz="1300" b="1"/>
            </a:lvl3pPr>
            <a:lvl4pPr marL="980145" indent="0">
              <a:buNone/>
              <a:defRPr sz="1100" b="1"/>
            </a:lvl4pPr>
            <a:lvl5pPr marL="1306860" indent="0">
              <a:buNone/>
              <a:defRPr sz="1100" b="1"/>
            </a:lvl5pPr>
            <a:lvl6pPr marL="1633576" indent="0">
              <a:buNone/>
              <a:defRPr sz="1100" b="1"/>
            </a:lvl6pPr>
            <a:lvl7pPr marL="1960291" indent="0">
              <a:buNone/>
              <a:defRPr sz="1100" b="1"/>
            </a:lvl7pPr>
            <a:lvl8pPr marL="2287006" indent="0">
              <a:buNone/>
              <a:defRPr sz="1100" b="1"/>
            </a:lvl8pPr>
            <a:lvl9pPr marL="2613721" indent="0">
              <a:buNone/>
              <a:defRPr sz="11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2904754" y="1813403"/>
            <a:ext cx="2527513" cy="3294569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3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85909" y="227668"/>
            <a:ext cx="1881240" cy="968913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235647" y="227668"/>
            <a:ext cx="3196619" cy="4880304"/>
          </a:xfrm>
        </p:spPr>
        <p:txBody>
          <a:bodyPr/>
          <a:lstStyle>
            <a:lvl1pPr>
              <a:defRPr sz="2300"/>
            </a:lvl1pPr>
            <a:lvl2pPr>
              <a:defRPr sz="2000"/>
            </a:lvl2pPr>
            <a:lvl3pPr>
              <a:defRPr sz="17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85909" y="1196581"/>
            <a:ext cx="1881240" cy="3911391"/>
          </a:xfrm>
        </p:spPr>
        <p:txBody>
          <a:bodyPr/>
          <a:lstStyle>
            <a:lvl1pPr marL="0" indent="0">
              <a:buNone/>
              <a:defRPr sz="1000"/>
            </a:lvl1pPr>
            <a:lvl2pPr marL="326715" indent="0">
              <a:buNone/>
              <a:defRPr sz="900"/>
            </a:lvl2pPr>
            <a:lvl3pPr marL="653430" indent="0">
              <a:buNone/>
              <a:defRPr sz="700"/>
            </a:lvl3pPr>
            <a:lvl4pPr marL="980145" indent="0">
              <a:buNone/>
              <a:defRPr sz="600"/>
            </a:lvl4pPr>
            <a:lvl5pPr marL="1306860" indent="0">
              <a:buNone/>
              <a:defRPr sz="600"/>
            </a:lvl5pPr>
            <a:lvl6pPr marL="1633576" indent="0">
              <a:buNone/>
              <a:defRPr sz="600"/>
            </a:lvl6pPr>
            <a:lvl7pPr marL="1960291" indent="0">
              <a:buNone/>
              <a:defRPr sz="600"/>
            </a:lvl7pPr>
            <a:lvl8pPr marL="2287006" indent="0">
              <a:buNone/>
              <a:defRPr sz="600"/>
            </a:lvl8pPr>
            <a:lvl9pPr marL="2613721" indent="0">
              <a:buNone/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120802" y="4002723"/>
            <a:ext cx="3430905" cy="472544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120802" y="510930"/>
            <a:ext cx="3430905" cy="3430905"/>
          </a:xfrm>
        </p:spPr>
        <p:txBody>
          <a:bodyPr/>
          <a:lstStyle>
            <a:lvl1pPr marL="0" indent="0">
              <a:buNone/>
              <a:defRPr sz="2300"/>
            </a:lvl1pPr>
            <a:lvl2pPr marL="326715" indent="0">
              <a:buNone/>
              <a:defRPr sz="2000"/>
            </a:lvl2pPr>
            <a:lvl3pPr marL="653430" indent="0">
              <a:buNone/>
              <a:defRPr sz="1700"/>
            </a:lvl3pPr>
            <a:lvl4pPr marL="980145" indent="0">
              <a:buNone/>
              <a:defRPr sz="1400"/>
            </a:lvl4pPr>
            <a:lvl5pPr marL="1306860" indent="0">
              <a:buNone/>
              <a:defRPr sz="1400"/>
            </a:lvl5pPr>
            <a:lvl6pPr marL="1633576" indent="0">
              <a:buNone/>
              <a:defRPr sz="1400"/>
            </a:lvl6pPr>
            <a:lvl7pPr marL="1960291" indent="0">
              <a:buNone/>
              <a:defRPr sz="1400"/>
            </a:lvl7pPr>
            <a:lvl8pPr marL="2287006" indent="0">
              <a:buNone/>
              <a:defRPr sz="1400"/>
            </a:lvl8pPr>
            <a:lvl9pPr marL="2613721" indent="0">
              <a:buNone/>
              <a:defRPr sz="14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120802" y="4475267"/>
            <a:ext cx="3430905" cy="671091"/>
          </a:xfrm>
        </p:spPr>
        <p:txBody>
          <a:bodyPr/>
          <a:lstStyle>
            <a:lvl1pPr marL="0" indent="0">
              <a:buNone/>
              <a:defRPr sz="1000"/>
            </a:lvl1pPr>
            <a:lvl2pPr marL="326715" indent="0">
              <a:buNone/>
              <a:defRPr sz="900"/>
            </a:lvl2pPr>
            <a:lvl3pPr marL="653430" indent="0">
              <a:buNone/>
              <a:defRPr sz="700"/>
            </a:lvl3pPr>
            <a:lvl4pPr marL="980145" indent="0">
              <a:buNone/>
              <a:defRPr sz="600"/>
            </a:lvl4pPr>
            <a:lvl5pPr marL="1306860" indent="0">
              <a:buNone/>
              <a:defRPr sz="600"/>
            </a:lvl5pPr>
            <a:lvl6pPr marL="1633576" indent="0">
              <a:buNone/>
              <a:defRPr sz="600"/>
            </a:lvl6pPr>
            <a:lvl7pPr marL="1960291" indent="0">
              <a:buNone/>
              <a:defRPr sz="600"/>
            </a:lvl7pPr>
            <a:lvl8pPr marL="2287006" indent="0">
              <a:buNone/>
              <a:defRPr sz="600"/>
            </a:lvl8pPr>
            <a:lvl9pPr marL="2613721" indent="0">
              <a:buNone/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285909" y="228992"/>
            <a:ext cx="5146358" cy="953029"/>
          </a:xfrm>
          <a:prstGeom prst="rect">
            <a:avLst/>
          </a:prstGeom>
        </p:spPr>
        <p:txBody>
          <a:bodyPr vert="horz" lIns="65343" tIns="32672" rIns="65343" bIns="32672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85909" y="1334241"/>
            <a:ext cx="5146358" cy="3773731"/>
          </a:xfrm>
          <a:prstGeom prst="rect">
            <a:avLst/>
          </a:prstGeom>
        </p:spPr>
        <p:txBody>
          <a:bodyPr vert="horz" lIns="65343" tIns="32672" rIns="65343" bIns="32672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285909" y="5299901"/>
            <a:ext cx="1334241" cy="304440"/>
          </a:xfrm>
          <a:prstGeom prst="rect">
            <a:avLst/>
          </a:prstGeom>
        </p:spPr>
        <p:txBody>
          <a:bodyPr vert="horz" lIns="65343" tIns="32672" rIns="65343" bIns="32672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1953710" y="5299901"/>
            <a:ext cx="1810755" cy="304440"/>
          </a:xfrm>
          <a:prstGeom prst="rect">
            <a:avLst/>
          </a:prstGeom>
        </p:spPr>
        <p:txBody>
          <a:bodyPr vert="horz" lIns="65343" tIns="32672" rIns="65343" bIns="32672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098025" y="5299901"/>
            <a:ext cx="1334241" cy="304440"/>
          </a:xfrm>
          <a:prstGeom prst="rect">
            <a:avLst/>
          </a:prstGeom>
        </p:spPr>
        <p:txBody>
          <a:bodyPr vert="horz" lIns="65343" tIns="32672" rIns="65343" bIns="32672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53430" rtl="0" eaLnBrk="1" latinLnBrk="0" hangingPunct="1">
        <a:spcBef>
          <a:spcPct val="0"/>
        </a:spcBef>
        <a:buNone/>
        <a:defRPr kumimoji="1" sz="3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5036" indent="-245036" algn="l" defTabSz="653430" rtl="0" eaLnBrk="1" latinLnBrk="0" hangingPunct="1">
        <a:spcBef>
          <a:spcPct val="20000"/>
        </a:spcBef>
        <a:buFont typeface="Arial" pitchFamily="34" charset="0"/>
        <a:buChar char="•"/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30912" indent="-204197" algn="l" defTabSz="65343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816788" indent="-163358" algn="l" defTabSz="653430" rtl="0" eaLnBrk="1" latinLnBrk="0" hangingPunct="1">
        <a:spcBef>
          <a:spcPct val="20000"/>
        </a:spcBef>
        <a:buFont typeface="Arial" pitchFamily="34" charset="0"/>
        <a:buChar char="•"/>
        <a:defRPr kumimoji="1"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143503" indent="-163358" algn="l" defTabSz="653430" rtl="0" eaLnBrk="1" latinLnBrk="0" hangingPunct="1">
        <a:spcBef>
          <a:spcPct val="20000"/>
        </a:spcBef>
        <a:buFont typeface="Arial" pitchFamily="34" charset="0"/>
        <a:buChar char="–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70218" indent="-163358" algn="l" defTabSz="653430" rtl="0" eaLnBrk="1" latinLnBrk="0" hangingPunct="1">
        <a:spcBef>
          <a:spcPct val="20000"/>
        </a:spcBef>
        <a:buFont typeface="Arial" pitchFamily="34" charset="0"/>
        <a:buChar char="»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96933" indent="-163358" algn="l" defTabSz="653430" rtl="0" eaLnBrk="1" latinLnBrk="0" hangingPunct="1">
        <a:spcBef>
          <a:spcPct val="20000"/>
        </a:spcBef>
        <a:buFont typeface="Arial" pitchFamily="34" charset="0"/>
        <a:buChar char="•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23648" indent="-163358" algn="l" defTabSz="653430" rtl="0" eaLnBrk="1" latinLnBrk="0" hangingPunct="1">
        <a:spcBef>
          <a:spcPct val="20000"/>
        </a:spcBef>
        <a:buFont typeface="Arial" pitchFamily="34" charset="0"/>
        <a:buChar char="•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50363" indent="-163358" algn="l" defTabSz="653430" rtl="0" eaLnBrk="1" latinLnBrk="0" hangingPunct="1">
        <a:spcBef>
          <a:spcPct val="20000"/>
        </a:spcBef>
        <a:buFont typeface="Arial" pitchFamily="34" charset="0"/>
        <a:buChar char="•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77079" indent="-163358" algn="l" defTabSz="653430" rtl="0" eaLnBrk="1" latinLnBrk="0" hangingPunct="1">
        <a:spcBef>
          <a:spcPct val="20000"/>
        </a:spcBef>
        <a:buFont typeface="Arial" pitchFamily="34" charset="0"/>
        <a:buChar char="•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53430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26715" algn="l" defTabSz="653430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53430" algn="l" defTabSz="653430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980145" algn="l" defTabSz="653430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06860" algn="l" defTabSz="653430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33576" algn="l" defTabSz="653430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960291" algn="l" defTabSz="653430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287006" algn="l" defTabSz="653430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613721" algn="l" defTabSz="653430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>
            <a:spLocks noChangeArrowheads="1"/>
          </p:cNvSpPr>
          <p:nvPr/>
        </p:nvSpPr>
        <p:spPr bwMode="auto">
          <a:xfrm rot="16200000">
            <a:off x="-316791" y="813455"/>
            <a:ext cx="1108214" cy="199362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90754" tIns="45377" rIns="90754" bIns="45377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US" altLang="ja-JP" sz="700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Tumor volume (mm</a:t>
            </a:r>
            <a:r>
              <a:rPr lang="en-US" altLang="ja-JP" sz="700" b="1" baseline="30000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3</a:t>
            </a:r>
            <a:r>
              <a:rPr lang="en-US" altLang="ja-JP" sz="700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) </a:t>
            </a:r>
            <a:endParaRPr lang="ja-JP" altLang="en-US" sz="700" b="1" dirty="0">
              <a:latin typeface="Helvetica" panose="020B0604020202020204" pitchFamily="34" charset="0"/>
              <a:ea typeface="+mn-ea"/>
              <a:cs typeface="Helvetica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9043" y="233232"/>
            <a:ext cx="269764" cy="246161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" name="左右矢印 6"/>
          <p:cNvSpPr/>
          <p:nvPr/>
        </p:nvSpPr>
        <p:spPr>
          <a:xfrm>
            <a:off x="627081" y="1651164"/>
            <a:ext cx="1971532" cy="60608"/>
          </a:xfrm>
          <a:prstGeom prst="left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801277" y="1730062"/>
            <a:ext cx="8255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133008" y="1723667"/>
            <a:ext cx="465605" cy="199994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sz="7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テキスト ボックス 10"/>
          <p:cNvSpPr txBox="1">
            <a:spLocks noChangeArrowheads="1"/>
          </p:cNvSpPr>
          <p:nvPr/>
        </p:nvSpPr>
        <p:spPr bwMode="auto">
          <a:xfrm rot="16200000">
            <a:off x="2686610" y="771299"/>
            <a:ext cx="883793" cy="199362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90754" tIns="45377" rIns="90754" bIns="45377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US" altLang="ja-JP" sz="700" b="1" dirty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Body </a:t>
            </a:r>
            <a:r>
              <a:rPr lang="en-US" altLang="ja-JP" sz="700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weight (g) </a:t>
            </a:r>
            <a:endParaRPr lang="ja-JP" altLang="en-US" sz="700" b="1" dirty="0">
              <a:latin typeface="Helvetica" panose="020B0604020202020204" pitchFamily="34" charset="0"/>
              <a:ea typeface="+mn-ea"/>
              <a:cs typeface="Helvetica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859087" y="233232"/>
            <a:ext cx="269764" cy="246161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endParaRPr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" name="左右矢印 15"/>
          <p:cNvSpPr/>
          <p:nvPr/>
        </p:nvSpPr>
        <p:spPr>
          <a:xfrm>
            <a:off x="3407835" y="1666404"/>
            <a:ext cx="1827516" cy="45719"/>
          </a:xfrm>
          <a:prstGeom prst="left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582031" y="1730062"/>
            <a:ext cx="8255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" name="テキスト ボックス 19"/>
          <p:cNvSpPr txBox="1">
            <a:spLocks noChangeArrowheads="1"/>
          </p:cNvSpPr>
          <p:nvPr/>
        </p:nvSpPr>
        <p:spPr bwMode="auto">
          <a:xfrm rot="16200000">
            <a:off x="-204580" y="4593440"/>
            <a:ext cx="883793" cy="199362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90754" tIns="45377" rIns="90754" bIns="45377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US" altLang="ja-JP" sz="700" b="1" dirty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Body </a:t>
            </a:r>
            <a:r>
              <a:rPr lang="en-US" altLang="ja-JP" sz="700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weight (g) </a:t>
            </a:r>
            <a:endParaRPr lang="ja-JP" altLang="en-US" sz="700" b="1" dirty="0">
              <a:latin typeface="Helvetica" panose="020B0604020202020204" pitchFamily="34" charset="0"/>
              <a:ea typeface="+mn-ea"/>
              <a:cs typeface="Helvetica" panose="020B0604020202020204" pitchFamily="34" charset="0"/>
            </a:endParaRPr>
          </a:p>
        </p:txBody>
      </p:sp>
      <p:sp>
        <p:nvSpPr>
          <p:cNvPr id="21" name="左右矢印 20"/>
          <p:cNvSpPr/>
          <p:nvPr/>
        </p:nvSpPr>
        <p:spPr>
          <a:xfrm>
            <a:off x="707796" y="5319136"/>
            <a:ext cx="999715" cy="66769"/>
          </a:xfrm>
          <a:prstGeom prst="left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814760" y="5395336"/>
            <a:ext cx="8255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69043" y="1923037"/>
            <a:ext cx="269764" cy="246161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  <a:endParaRPr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" name="テキスト ボックス 25"/>
          <p:cNvSpPr txBox="1">
            <a:spLocks noChangeArrowheads="1"/>
          </p:cNvSpPr>
          <p:nvPr/>
        </p:nvSpPr>
        <p:spPr bwMode="auto">
          <a:xfrm rot="16200000">
            <a:off x="2668573" y="4517240"/>
            <a:ext cx="883793" cy="199362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90754" tIns="45377" rIns="90754" bIns="45377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US" altLang="ja-JP" sz="700" b="1" dirty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Body </a:t>
            </a:r>
            <a:r>
              <a:rPr lang="en-US" altLang="ja-JP" sz="700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weight (g) </a:t>
            </a:r>
            <a:endParaRPr lang="ja-JP" altLang="en-US" sz="700" b="1" dirty="0">
              <a:latin typeface="Helvetica" panose="020B0604020202020204" pitchFamily="34" charset="0"/>
              <a:ea typeface="+mn-ea"/>
              <a:cs typeface="Helvetica" panose="020B0604020202020204" pitchFamily="34" charset="0"/>
            </a:endParaRPr>
          </a:p>
        </p:txBody>
      </p:sp>
      <p:sp>
        <p:nvSpPr>
          <p:cNvPr id="27" name="左右矢印 26"/>
          <p:cNvSpPr/>
          <p:nvPr/>
        </p:nvSpPr>
        <p:spPr>
          <a:xfrm>
            <a:off x="3396240" y="5319136"/>
            <a:ext cx="999715" cy="66769"/>
          </a:xfrm>
          <a:prstGeom prst="left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503204" y="5395336"/>
            <a:ext cx="8255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859087" y="1923037"/>
            <a:ext cx="269764" cy="246161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  <a:endParaRPr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2" name="テキスト ボックス 31"/>
          <p:cNvSpPr txBox="1">
            <a:spLocks noChangeArrowheads="1"/>
          </p:cNvSpPr>
          <p:nvPr/>
        </p:nvSpPr>
        <p:spPr bwMode="auto">
          <a:xfrm rot="16200000">
            <a:off x="-316791" y="2655871"/>
            <a:ext cx="1108214" cy="199362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90754" tIns="45377" rIns="90754" bIns="45377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US" altLang="ja-JP" sz="700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Tumor volume (mm</a:t>
            </a:r>
            <a:r>
              <a:rPr lang="en-US" altLang="ja-JP" sz="700" b="1" baseline="30000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3</a:t>
            </a:r>
            <a:r>
              <a:rPr lang="en-US" altLang="ja-JP" sz="700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) </a:t>
            </a:r>
            <a:endParaRPr lang="ja-JP" altLang="en-US" sz="700" b="1" dirty="0">
              <a:latin typeface="Helvetica" panose="020B0604020202020204" pitchFamily="34" charset="0"/>
              <a:ea typeface="+mn-ea"/>
              <a:cs typeface="Helvetica" panose="020B0604020202020204" pitchFamily="34" charset="0"/>
            </a:endParaRPr>
          </a:p>
        </p:txBody>
      </p:sp>
      <p:sp>
        <p:nvSpPr>
          <p:cNvPr id="33" name="左右矢印 32"/>
          <p:cNvSpPr/>
          <p:nvPr/>
        </p:nvSpPr>
        <p:spPr>
          <a:xfrm>
            <a:off x="610421" y="3541221"/>
            <a:ext cx="1016375" cy="45719"/>
          </a:xfrm>
          <a:prstGeom prst="left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784617" y="3567513"/>
            <a:ext cx="8255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69043" y="3814673"/>
            <a:ext cx="269764" cy="246161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E</a:t>
            </a:r>
            <a:endParaRPr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テキスト ボックス 37"/>
          <p:cNvSpPr txBox="1">
            <a:spLocks noChangeArrowheads="1"/>
          </p:cNvSpPr>
          <p:nvPr/>
        </p:nvSpPr>
        <p:spPr bwMode="auto">
          <a:xfrm rot="16200000">
            <a:off x="2457620" y="2589604"/>
            <a:ext cx="1108214" cy="199362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90754" tIns="45377" rIns="90754" bIns="45377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US" altLang="ja-JP" sz="700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Tumor volume (mm</a:t>
            </a:r>
            <a:r>
              <a:rPr lang="en-US" altLang="ja-JP" sz="700" b="1" baseline="30000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3</a:t>
            </a:r>
            <a:r>
              <a:rPr lang="en-US" altLang="ja-JP" sz="700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) </a:t>
            </a:r>
            <a:endParaRPr lang="ja-JP" altLang="en-US" sz="700" b="1" dirty="0">
              <a:latin typeface="Helvetica" panose="020B0604020202020204" pitchFamily="34" charset="0"/>
              <a:ea typeface="+mn-ea"/>
              <a:cs typeface="Helvetica" panose="020B0604020202020204" pitchFamily="34" charset="0"/>
            </a:endParaRPr>
          </a:p>
        </p:txBody>
      </p:sp>
      <p:sp>
        <p:nvSpPr>
          <p:cNvPr id="39" name="左右矢印 38"/>
          <p:cNvSpPr/>
          <p:nvPr/>
        </p:nvSpPr>
        <p:spPr>
          <a:xfrm>
            <a:off x="3407835" y="3537891"/>
            <a:ext cx="1052673" cy="45719"/>
          </a:xfrm>
          <a:prstGeom prst="left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618329" y="3564183"/>
            <a:ext cx="8255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859087" y="3814673"/>
            <a:ext cx="269764" cy="246161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F</a:t>
            </a:r>
            <a:endParaRPr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43" name="グラフ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7836008"/>
              </p:ext>
            </p:extLst>
          </p:nvPr>
        </p:nvGraphicFramePr>
        <p:xfrm>
          <a:off x="336066" y="264564"/>
          <a:ext cx="2532312" cy="14591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4" name="グラフ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0079782"/>
              </p:ext>
            </p:extLst>
          </p:nvPr>
        </p:nvGraphicFramePr>
        <p:xfrm>
          <a:off x="3164364" y="260322"/>
          <a:ext cx="2592288" cy="1448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5" name="グラフ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9007429"/>
              </p:ext>
            </p:extLst>
          </p:nvPr>
        </p:nvGraphicFramePr>
        <p:xfrm>
          <a:off x="3137437" y="1975026"/>
          <a:ext cx="2480729" cy="16380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6" name="グラフ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0881007"/>
              </p:ext>
            </p:extLst>
          </p:nvPr>
        </p:nvGraphicFramePr>
        <p:xfrm>
          <a:off x="3028825" y="4045048"/>
          <a:ext cx="2575626" cy="12961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7" name="グラフ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1359130"/>
              </p:ext>
            </p:extLst>
          </p:nvPr>
        </p:nvGraphicFramePr>
        <p:xfrm>
          <a:off x="328389" y="1999316"/>
          <a:ext cx="2414240" cy="1587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8" name="グラフ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39894707"/>
              </p:ext>
            </p:extLst>
          </p:nvPr>
        </p:nvGraphicFramePr>
        <p:xfrm>
          <a:off x="509982" y="4069742"/>
          <a:ext cx="2465333" cy="11961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49" name="テキスト ボックス 2"/>
          <p:cNvSpPr txBox="1"/>
          <p:nvPr/>
        </p:nvSpPr>
        <p:spPr>
          <a:xfrm>
            <a:off x="-60411" y="50775"/>
            <a:ext cx="7682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64484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328969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493454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57937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822421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986906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151390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315873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b="1" dirty="0" err="1" smtClean="0"/>
              <a:t>Supp</a:t>
            </a:r>
            <a:r>
              <a:rPr kumimoji="1" lang="en-US" altLang="ja-JP" sz="800" b="1" dirty="0" smtClean="0"/>
              <a:t> Figure2</a:t>
            </a:r>
            <a:endParaRPr kumimoji="1" lang="ja-JP" altLang="en-US" sz="800" b="1" dirty="0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4823613" y="1721679"/>
            <a:ext cx="465605" cy="199994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sz="7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420497" y="5214415"/>
            <a:ext cx="465605" cy="199994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sz="7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213054" y="3460753"/>
            <a:ext cx="465605" cy="199994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sz="7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5073274" y="3480517"/>
            <a:ext cx="465605" cy="199994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sz="7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5030106" y="5276044"/>
            <a:ext cx="465605" cy="199994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sz="7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30540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</TotalTime>
  <Words>68</Words>
  <Application>Microsoft Office PowerPoint</Application>
  <PresentationFormat>ユーザー設定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Helvetica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ichiro</dc:creator>
  <cp:lastModifiedBy>kadoaki</cp:lastModifiedBy>
  <cp:revision>28</cp:revision>
  <dcterms:created xsi:type="dcterms:W3CDTF">2016-08-27T14:31:23Z</dcterms:created>
  <dcterms:modified xsi:type="dcterms:W3CDTF">2017-03-26T02:51:38Z</dcterms:modified>
</cp:coreProperties>
</file>